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1" r:id="rId2"/>
    <p:sldId id="272" r:id="rId3"/>
    <p:sldId id="315" r:id="rId4"/>
    <p:sldId id="31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014"/>
    <p:restoredTop sz="96341"/>
  </p:normalViewPr>
  <p:slideViewPr>
    <p:cSldViewPr snapToGrid="0" snapToObjects="1">
      <p:cViewPr varScale="1">
        <p:scale>
          <a:sx n="123" d="100"/>
          <a:sy n="123" d="100"/>
        </p:scale>
        <p:origin x="5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787EFF-3E0E-6543-AEF3-22086AC00FF7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E902D0-0062-A34D-932A-6EA31D59AD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498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A86796-0A55-AE4B-A8B5-FA1BCBC268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2937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BD7C3C-8A15-CE48-846C-7AF0D13873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C6B55B-B6A2-A54A-A7E3-A7391AE6D9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3AA56-C8D4-DF48-9C04-70F0B4528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DEDABD-2CAF-AC48-90CE-4F316D4C3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A438F8-1E0F-2F40-9922-356E9219B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983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DC10C7-A4E6-064C-87AA-E6352BEC3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190E7A-285D-C643-9B00-E29E6DAB5B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A3C93A-2B94-C844-866A-8D99C74C5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F7BF8-4C13-E14A-BC31-17498738C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DEA48E-9BF2-A747-8ADF-568EDBD2F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362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E30A69-798F-464F-BFD7-2E9F80A3DB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C9F61C-2082-3248-BBCC-9ECC9F688E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112509-85F8-A444-96AB-336011BEB2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1096DD-AB93-754D-9D82-F0648BF2B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D8B9E-3A3D-684A-BA03-FED51A57C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845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A1ABC-02E3-794B-8BF2-A9000722A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DAC741-231D-7240-88B0-82CFE5AE5A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A17269-B4EE-D44A-B613-D44DBFA49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0AC7F3-31C4-104D-B9A3-A3D539DCB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B559B-CA14-0448-8116-3CBC76F76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81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76ADE5-0215-644D-8A6E-B88694CC5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B7B52B-AA01-1F46-BD3E-8B11FC88E8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E970CF-A86B-D84F-AD81-F49213DFA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D7119-56FE-AA46-B3B5-B3CC2599F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7DF1C8-7CCB-3944-8D99-84EAEE11B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489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AB3B4-8632-6B4D-B5A2-16BC166189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38234A-FA73-DA42-A24B-2D1ED3FAB8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08AB28-7770-6D4D-8BAC-B47227770B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9C40CC-ED4F-164D-B2EF-69789D0AA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F4B26E-DA3D-AF4D-9538-D8F4300D4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FB917B-C9B6-6642-914A-3C142AC6F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998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EF776E-6E17-4D4C-80F9-26E06DCDC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E72F45-C31C-E54E-85C5-38F2EF66D1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96EFBA-0DA3-C448-9860-51A5FB193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D8E9F4-57DB-FD48-B05F-043FB2DFBA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BB39B6-4E7D-9F4A-B988-121F28B223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CE37D6-D7A0-4345-993B-BBFB777AB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FDCD0A-C720-5048-8349-7948D2C17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5EEEC7-B6EF-9448-9926-BD42C0D70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552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6F688-8DC1-C247-B771-E38FF0296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AB9FF6-F61A-0B4F-9590-A73466450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30135E-E01C-FD48-9B70-E6EDCB11F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FBE6E2-9849-7849-8B05-FB85294C6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611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D9A4A0-A0C4-D94D-8290-14868F27A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FB976F-C014-B54C-B748-61379A912C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B0721B-97CC-9A40-89A4-63502BC0D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176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789D16-B6E4-9143-8062-7E1489723A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CF385D-FC0C-D44E-9D54-2F128C1A49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AE89E6-76DA-9247-A2F0-6496B30051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051CB3-7C4F-6546-BEE0-C3284307C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9EB98A-1304-024B-9D72-83F6E340F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D14576-4641-FE4F-BCC1-08C528BE0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443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29A1A4-7395-6B4A-83C9-AE9EF64E8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C2EDFA-AD35-174E-9073-DA08BFC0FD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3D55F3-08D0-A942-B988-4EEF2B3BA8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9298EB-3C16-584C-A52E-ED50E6489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7A629E-1573-834C-9975-9AECC1471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345C6C-11A2-B843-B09E-30528A82B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530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19D7AE-3757-FF46-B096-3FD304694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30F617-A75C-B545-A012-06D5C150B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3D202-B33D-D346-BE2A-EE5405C25D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4F12E-E6D8-6048-8687-6CDBB27B5DA0}" type="datetimeFigureOut">
              <a:rPr lang="en-US" smtClean="0"/>
              <a:t>10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536B21-CE8D-9649-B664-40B480322D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73F0E2-5BFB-1840-BF47-25FA086E3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0E426-1BE5-9442-82D3-C993ADFD5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88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9BA1644-E00A-BD40-BCEC-FF3D48C13B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159" r="22222" b="10477"/>
          <a:stretch/>
        </p:blipFill>
        <p:spPr>
          <a:xfrm>
            <a:off x="1242680" y="487572"/>
            <a:ext cx="9462163" cy="6034543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419E0280-8A02-4341-A9F9-AA99895AABE6}"/>
              </a:ext>
            </a:extLst>
          </p:cNvPr>
          <p:cNvSpPr txBox="1">
            <a:spLocks/>
          </p:cNvSpPr>
          <p:nvPr/>
        </p:nvSpPr>
        <p:spPr>
          <a:xfrm>
            <a:off x="1535888" y="130123"/>
            <a:ext cx="368633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F0E32F44-1E11-FD48-80A8-AF52AED1D7A1}"/>
              </a:ext>
            </a:extLst>
          </p:cNvPr>
          <p:cNvSpPr txBox="1">
            <a:spLocks/>
          </p:cNvSpPr>
          <p:nvPr/>
        </p:nvSpPr>
        <p:spPr>
          <a:xfrm>
            <a:off x="2784255" y="5294937"/>
            <a:ext cx="712965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us Rhythm Bipolar Endocardial Voltage Map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0CBB5CBA-4E90-424A-B8A6-FD6666228131}"/>
              </a:ext>
            </a:extLst>
          </p:cNvPr>
          <p:cNvSpPr txBox="1">
            <a:spLocks/>
          </p:cNvSpPr>
          <p:nvPr/>
        </p:nvSpPr>
        <p:spPr>
          <a:xfrm>
            <a:off x="4078665" y="2242883"/>
            <a:ext cx="671461" cy="8209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V</a:t>
            </a: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71CA2A03-A613-DA4B-B3AC-0593DEAB5575}"/>
              </a:ext>
            </a:extLst>
          </p:cNvPr>
          <p:cNvSpPr txBox="1">
            <a:spLocks/>
          </p:cNvSpPr>
          <p:nvPr/>
        </p:nvSpPr>
        <p:spPr>
          <a:xfrm>
            <a:off x="9242452" y="2242882"/>
            <a:ext cx="671461" cy="8209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V</a:t>
            </a:r>
          </a:p>
        </p:txBody>
      </p:sp>
    </p:spTree>
    <p:extLst>
      <p:ext uri="{BB962C8B-B14F-4D97-AF65-F5344CB8AC3E}">
        <p14:creationId xmlns:p14="http://schemas.microsoft.com/office/powerpoint/2010/main" val="39106644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AA011AF-F8A0-F845-805D-214990D046E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69" r="57272" b="9842"/>
          <a:stretch/>
        </p:blipFill>
        <p:spPr>
          <a:xfrm>
            <a:off x="3063741" y="365125"/>
            <a:ext cx="5525623" cy="6102559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7134D690-D91F-6E46-972A-C04D0886D149}"/>
              </a:ext>
            </a:extLst>
          </p:cNvPr>
          <p:cNvSpPr txBox="1">
            <a:spLocks/>
          </p:cNvSpPr>
          <p:nvPr/>
        </p:nvSpPr>
        <p:spPr>
          <a:xfrm>
            <a:off x="3374037" y="187741"/>
            <a:ext cx="368633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2C8F175E-DB15-B94A-94E1-2623773B7C10}"/>
              </a:ext>
            </a:extLst>
          </p:cNvPr>
          <p:cNvSpPr txBox="1">
            <a:spLocks/>
          </p:cNvSpPr>
          <p:nvPr/>
        </p:nvSpPr>
        <p:spPr>
          <a:xfrm>
            <a:off x="3553416" y="5142121"/>
            <a:ext cx="523502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us Rhythm Bipolar </a:t>
            </a:r>
          </a:p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ocardial Voltage Map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5AEFE1D5-583E-E64E-909A-374EAB356FEC}"/>
              </a:ext>
            </a:extLst>
          </p:cNvPr>
          <p:cNvSpPr txBox="1">
            <a:spLocks/>
          </p:cNvSpPr>
          <p:nvPr/>
        </p:nvSpPr>
        <p:spPr>
          <a:xfrm>
            <a:off x="6170927" y="1980166"/>
            <a:ext cx="671461" cy="8209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V</a:t>
            </a:r>
          </a:p>
        </p:txBody>
      </p:sp>
    </p:spTree>
    <p:extLst>
      <p:ext uri="{BB962C8B-B14F-4D97-AF65-F5344CB8AC3E}">
        <p14:creationId xmlns:p14="http://schemas.microsoft.com/office/powerpoint/2010/main" val="3724948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8B64008-05BA-BA42-8F71-3E8A3FF040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99" t="8032" r="57092" b="27001"/>
          <a:stretch/>
        </p:blipFill>
        <p:spPr>
          <a:xfrm>
            <a:off x="2111415" y="1413012"/>
            <a:ext cx="4473703" cy="483113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462ABAB-02B1-1747-9064-92F9BB3181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664" t="9836" r="22632" b="13442"/>
          <a:stretch/>
        </p:blipFill>
        <p:spPr>
          <a:xfrm>
            <a:off x="6626971" y="1413012"/>
            <a:ext cx="4118275" cy="4833030"/>
          </a:xfrm>
          <a:prstGeom prst="rect">
            <a:avLst/>
          </a:prstGeom>
        </p:spPr>
      </p:pic>
      <p:sp>
        <p:nvSpPr>
          <p:cNvPr id="5" name="Freeform 4">
            <a:extLst>
              <a:ext uri="{FF2B5EF4-FFF2-40B4-BE49-F238E27FC236}">
                <a16:creationId xmlns:a16="http://schemas.microsoft.com/office/drawing/2014/main" id="{98715E80-B1DF-0C4A-ACE1-0E5A2C6B832B}"/>
              </a:ext>
            </a:extLst>
          </p:cNvPr>
          <p:cNvSpPr/>
          <p:nvPr/>
        </p:nvSpPr>
        <p:spPr>
          <a:xfrm flipV="1">
            <a:off x="2916279" y="3715234"/>
            <a:ext cx="327139" cy="91028"/>
          </a:xfrm>
          <a:custGeom>
            <a:avLst/>
            <a:gdLst>
              <a:gd name="connsiteX0" fmla="*/ 0 w 1428750"/>
              <a:gd name="connsiteY0" fmla="*/ 57150 h 519362"/>
              <a:gd name="connsiteX1" fmla="*/ 71437 w 1428750"/>
              <a:gd name="connsiteY1" fmla="*/ 28575 h 519362"/>
              <a:gd name="connsiteX2" fmla="*/ 157162 w 1428750"/>
              <a:gd name="connsiteY2" fmla="*/ 0 h 519362"/>
              <a:gd name="connsiteX3" fmla="*/ 314325 w 1428750"/>
              <a:gd name="connsiteY3" fmla="*/ 28575 h 519362"/>
              <a:gd name="connsiteX4" fmla="*/ 400050 w 1428750"/>
              <a:gd name="connsiteY4" fmla="*/ 71438 h 519362"/>
              <a:gd name="connsiteX5" fmla="*/ 514350 w 1428750"/>
              <a:gd name="connsiteY5" fmla="*/ 85725 h 519362"/>
              <a:gd name="connsiteX6" fmla="*/ 614362 w 1428750"/>
              <a:gd name="connsiteY6" fmla="*/ 100013 h 519362"/>
              <a:gd name="connsiteX7" fmla="*/ 657225 w 1428750"/>
              <a:gd name="connsiteY7" fmla="*/ 128588 h 519362"/>
              <a:gd name="connsiteX8" fmla="*/ 685800 w 1428750"/>
              <a:gd name="connsiteY8" fmla="*/ 214313 h 519362"/>
              <a:gd name="connsiteX9" fmla="*/ 771525 w 1428750"/>
              <a:gd name="connsiteY9" fmla="*/ 157163 h 519362"/>
              <a:gd name="connsiteX10" fmla="*/ 914400 w 1428750"/>
              <a:gd name="connsiteY10" fmla="*/ 200025 h 519362"/>
              <a:gd name="connsiteX11" fmla="*/ 957262 w 1428750"/>
              <a:gd name="connsiteY11" fmla="*/ 214313 h 519362"/>
              <a:gd name="connsiteX12" fmla="*/ 1042987 w 1428750"/>
              <a:gd name="connsiteY12" fmla="*/ 228600 h 519362"/>
              <a:gd name="connsiteX13" fmla="*/ 1085850 w 1428750"/>
              <a:gd name="connsiteY13" fmla="*/ 242888 h 519362"/>
              <a:gd name="connsiteX14" fmla="*/ 1214437 w 1428750"/>
              <a:gd name="connsiteY14" fmla="*/ 342900 h 519362"/>
              <a:gd name="connsiteX15" fmla="*/ 1243012 w 1428750"/>
              <a:gd name="connsiteY15" fmla="*/ 385763 h 519362"/>
              <a:gd name="connsiteX16" fmla="*/ 1271587 w 1428750"/>
              <a:gd name="connsiteY16" fmla="*/ 471488 h 519362"/>
              <a:gd name="connsiteX17" fmla="*/ 1300162 w 1428750"/>
              <a:gd name="connsiteY17" fmla="*/ 514350 h 519362"/>
              <a:gd name="connsiteX18" fmla="*/ 1428750 w 1428750"/>
              <a:gd name="connsiteY18" fmla="*/ 514350 h 5193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428750" h="519362">
                <a:moveTo>
                  <a:pt x="0" y="57150"/>
                </a:moveTo>
                <a:cubicBezTo>
                  <a:pt x="23812" y="47625"/>
                  <a:pt x="47334" y="37340"/>
                  <a:pt x="71437" y="28575"/>
                </a:cubicBezTo>
                <a:cubicBezTo>
                  <a:pt x="99744" y="18281"/>
                  <a:pt x="157162" y="0"/>
                  <a:pt x="157162" y="0"/>
                </a:cubicBezTo>
                <a:cubicBezTo>
                  <a:pt x="196555" y="4924"/>
                  <a:pt x="270278" y="6552"/>
                  <a:pt x="314325" y="28575"/>
                </a:cubicBezTo>
                <a:cubicBezTo>
                  <a:pt x="366618" y="54721"/>
                  <a:pt x="343616" y="61177"/>
                  <a:pt x="400050" y="71438"/>
                </a:cubicBezTo>
                <a:cubicBezTo>
                  <a:pt x="437827" y="78307"/>
                  <a:pt x="476290" y="80650"/>
                  <a:pt x="514350" y="85725"/>
                </a:cubicBezTo>
                <a:lnTo>
                  <a:pt x="614362" y="100013"/>
                </a:lnTo>
                <a:cubicBezTo>
                  <a:pt x="628650" y="109538"/>
                  <a:pt x="648124" y="114027"/>
                  <a:pt x="657225" y="128588"/>
                </a:cubicBezTo>
                <a:cubicBezTo>
                  <a:pt x="673189" y="154130"/>
                  <a:pt x="685800" y="214313"/>
                  <a:pt x="685800" y="214313"/>
                </a:cubicBezTo>
                <a:cubicBezTo>
                  <a:pt x="714375" y="195263"/>
                  <a:pt x="738207" y="148834"/>
                  <a:pt x="771525" y="157163"/>
                </a:cubicBezTo>
                <a:cubicBezTo>
                  <a:pt x="857892" y="178754"/>
                  <a:pt x="810053" y="165242"/>
                  <a:pt x="914400" y="200025"/>
                </a:cubicBezTo>
                <a:cubicBezTo>
                  <a:pt x="928687" y="204788"/>
                  <a:pt x="942407" y="211837"/>
                  <a:pt x="957262" y="214313"/>
                </a:cubicBezTo>
                <a:lnTo>
                  <a:pt x="1042987" y="228600"/>
                </a:lnTo>
                <a:cubicBezTo>
                  <a:pt x="1057275" y="233363"/>
                  <a:pt x="1072685" y="235574"/>
                  <a:pt x="1085850" y="242888"/>
                </a:cubicBezTo>
                <a:cubicBezTo>
                  <a:pt x="1135288" y="270354"/>
                  <a:pt x="1178531" y="299812"/>
                  <a:pt x="1214437" y="342900"/>
                </a:cubicBezTo>
                <a:cubicBezTo>
                  <a:pt x="1225430" y="356092"/>
                  <a:pt x="1236038" y="370071"/>
                  <a:pt x="1243012" y="385763"/>
                </a:cubicBezTo>
                <a:cubicBezTo>
                  <a:pt x="1255245" y="413288"/>
                  <a:pt x="1254879" y="446426"/>
                  <a:pt x="1271587" y="471488"/>
                </a:cubicBezTo>
                <a:cubicBezTo>
                  <a:pt x="1281112" y="485775"/>
                  <a:pt x="1283596" y="509832"/>
                  <a:pt x="1300162" y="514350"/>
                </a:cubicBezTo>
                <a:cubicBezTo>
                  <a:pt x="1341514" y="525628"/>
                  <a:pt x="1385887" y="514350"/>
                  <a:pt x="1428750" y="514350"/>
                </a:cubicBezTo>
              </a:path>
            </a:pathLst>
          </a:custGeom>
          <a:noFill/>
          <a:ln w="857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5A0126E4-1B21-954F-ABD4-6097A01DFAE9}"/>
              </a:ext>
            </a:extLst>
          </p:cNvPr>
          <p:cNvSpPr/>
          <p:nvPr/>
        </p:nvSpPr>
        <p:spPr>
          <a:xfrm>
            <a:off x="2549370" y="4502077"/>
            <a:ext cx="1543050" cy="523981"/>
          </a:xfrm>
          <a:custGeom>
            <a:avLst/>
            <a:gdLst>
              <a:gd name="connsiteX0" fmla="*/ 0 w 1543050"/>
              <a:gd name="connsiteY0" fmla="*/ 385763 h 523981"/>
              <a:gd name="connsiteX1" fmla="*/ 14288 w 1543050"/>
              <a:gd name="connsiteY1" fmla="*/ 457200 h 523981"/>
              <a:gd name="connsiteX2" fmla="*/ 57150 w 1543050"/>
              <a:gd name="connsiteY2" fmla="*/ 471488 h 523981"/>
              <a:gd name="connsiteX3" fmla="*/ 185738 w 1543050"/>
              <a:gd name="connsiteY3" fmla="*/ 442913 h 523981"/>
              <a:gd name="connsiteX4" fmla="*/ 271463 w 1543050"/>
              <a:gd name="connsiteY4" fmla="*/ 400050 h 523981"/>
              <a:gd name="connsiteX5" fmla="*/ 285750 w 1543050"/>
              <a:gd name="connsiteY5" fmla="*/ 442913 h 523981"/>
              <a:gd name="connsiteX6" fmla="*/ 300038 w 1543050"/>
              <a:gd name="connsiteY6" fmla="*/ 500063 h 523981"/>
              <a:gd name="connsiteX7" fmla="*/ 385763 w 1543050"/>
              <a:gd name="connsiteY7" fmla="*/ 457200 h 523981"/>
              <a:gd name="connsiteX8" fmla="*/ 528638 w 1543050"/>
              <a:gd name="connsiteY8" fmla="*/ 485775 h 523981"/>
              <a:gd name="connsiteX9" fmla="*/ 585788 w 1543050"/>
              <a:gd name="connsiteY9" fmla="*/ 400050 h 523981"/>
              <a:gd name="connsiteX10" fmla="*/ 571500 w 1543050"/>
              <a:gd name="connsiteY10" fmla="*/ 257175 h 523981"/>
              <a:gd name="connsiteX11" fmla="*/ 657225 w 1543050"/>
              <a:gd name="connsiteY11" fmla="*/ 228600 h 523981"/>
              <a:gd name="connsiteX12" fmla="*/ 700088 w 1543050"/>
              <a:gd name="connsiteY12" fmla="*/ 200025 h 523981"/>
              <a:gd name="connsiteX13" fmla="*/ 728663 w 1543050"/>
              <a:gd name="connsiteY13" fmla="*/ 157163 h 523981"/>
              <a:gd name="connsiteX14" fmla="*/ 800100 w 1543050"/>
              <a:gd name="connsiteY14" fmla="*/ 142875 h 523981"/>
              <a:gd name="connsiteX15" fmla="*/ 842963 w 1543050"/>
              <a:gd name="connsiteY15" fmla="*/ 128588 h 523981"/>
              <a:gd name="connsiteX16" fmla="*/ 928688 w 1543050"/>
              <a:gd name="connsiteY16" fmla="*/ 157163 h 523981"/>
              <a:gd name="connsiteX17" fmla="*/ 971550 w 1543050"/>
              <a:gd name="connsiteY17" fmla="*/ 171450 h 523981"/>
              <a:gd name="connsiteX18" fmla="*/ 1228725 w 1543050"/>
              <a:gd name="connsiteY18" fmla="*/ 171450 h 523981"/>
              <a:gd name="connsiteX19" fmla="*/ 1414463 w 1543050"/>
              <a:gd name="connsiteY19" fmla="*/ 157163 h 523981"/>
              <a:gd name="connsiteX20" fmla="*/ 1443038 w 1543050"/>
              <a:gd name="connsiteY20" fmla="*/ 71438 h 523981"/>
              <a:gd name="connsiteX21" fmla="*/ 1457325 w 1543050"/>
              <a:gd name="connsiteY21" fmla="*/ 28575 h 523981"/>
              <a:gd name="connsiteX22" fmla="*/ 1500188 w 1543050"/>
              <a:gd name="connsiteY22" fmla="*/ 0 h 523981"/>
              <a:gd name="connsiteX23" fmla="*/ 1543050 w 1543050"/>
              <a:gd name="connsiteY23" fmla="*/ 14288 h 5239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</a:cxnLst>
            <a:rect l="l" t="t" r="r" b="b"/>
            <a:pathLst>
              <a:path w="1543050" h="523981">
                <a:moveTo>
                  <a:pt x="0" y="385763"/>
                </a:moveTo>
                <a:cubicBezTo>
                  <a:pt x="4763" y="409575"/>
                  <a:pt x="818" y="436995"/>
                  <a:pt x="14288" y="457200"/>
                </a:cubicBezTo>
                <a:cubicBezTo>
                  <a:pt x="22642" y="469731"/>
                  <a:pt x="42090" y="471488"/>
                  <a:pt x="57150" y="471488"/>
                </a:cubicBezTo>
                <a:cubicBezTo>
                  <a:pt x="107436" y="471488"/>
                  <a:pt x="141539" y="457645"/>
                  <a:pt x="185738" y="442913"/>
                </a:cubicBezTo>
                <a:cubicBezTo>
                  <a:pt x="192957" y="438100"/>
                  <a:pt x="254562" y="391600"/>
                  <a:pt x="271463" y="400050"/>
                </a:cubicBezTo>
                <a:cubicBezTo>
                  <a:pt x="284933" y="406785"/>
                  <a:pt x="281613" y="428432"/>
                  <a:pt x="285750" y="442913"/>
                </a:cubicBezTo>
                <a:cubicBezTo>
                  <a:pt x="291144" y="461794"/>
                  <a:pt x="295275" y="481013"/>
                  <a:pt x="300038" y="500063"/>
                </a:cubicBezTo>
                <a:cubicBezTo>
                  <a:pt x="366713" y="400051"/>
                  <a:pt x="338138" y="385763"/>
                  <a:pt x="385763" y="457200"/>
                </a:cubicBezTo>
                <a:cubicBezTo>
                  <a:pt x="407633" y="522813"/>
                  <a:pt x="402419" y="553739"/>
                  <a:pt x="528638" y="485775"/>
                </a:cubicBezTo>
                <a:cubicBezTo>
                  <a:pt x="558876" y="469493"/>
                  <a:pt x="585788" y="400050"/>
                  <a:pt x="585788" y="400050"/>
                </a:cubicBezTo>
                <a:cubicBezTo>
                  <a:pt x="577992" y="376662"/>
                  <a:pt x="532314" y="290764"/>
                  <a:pt x="571500" y="257175"/>
                </a:cubicBezTo>
                <a:cubicBezTo>
                  <a:pt x="594369" y="237573"/>
                  <a:pt x="632163" y="245308"/>
                  <a:pt x="657225" y="228600"/>
                </a:cubicBezTo>
                <a:lnTo>
                  <a:pt x="700088" y="200025"/>
                </a:lnTo>
                <a:cubicBezTo>
                  <a:pt x="709613" y="185738"/>
                  <a:pt x="713754" y="165682"/>
                  <a:pt x="728663" y="157163"/>
                </a:cubicBezTo>
                <a:cubicBezTo>
                  <a:pt x="749747" y="145115"/>
                  <a:pt x="776541" y="148765"/>
                  <a:pt x="800100" y="142875"/>
                </a:cubicBezTo>
                <a:cubicBezTo>
                  <a:pt x="814711" y="139222"/>
                  <a:pt x="828675" y="133350"/>
                  <a:pt x="842963" y="128588"/>
                </a:cubicBezTo>
                <a:lnTo>
                  <a:pt x="928688" y="157163"/>
                </a:lnTo>
                <a:lnTo>
                  <a:pt x="971550" y="171450"/>
                </a:lnTo>
                <a:cubicBezTo>
                  <a:pt x="1164438" y="139303"/>
                  <a:pt x="928246" y="171450"/>
                  <a:pt x="1228725" y="171450"/>
                </a:cubicBezTo>
                <a:cubicBezTo>
                  <a:pt x="1290821" y="171450"/>
                  <a:pt x="1352550" y="161925"/>
                  <a:pt x="1414463" y="157163"/>
                </a:cubicBezTo>
                <a:lnTo>
                  <a:pt x="1443038" y="71438"/>
                </a:lnTo>
                <a:cubicBezTo>
                  <a:pt x="1447800" y="57150"/>
                  <a:pt x="1444794" y="36929"/>
                  <a:pt x="1457325" y="28575"/>
                </a:cubicBezTo>
                <a:lnTo>
                  <a:pt x="1500188" y="0"/>
                </a:lnTo>
                <a:lnTo>
                  <a:pt x="1543050" y="14288"/>
                </a:lnTo>
              </a:path>
            </a:pathLst>
          </a:custGeom>
          <a:noFill/>
          <a:ln w="857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BDBB9C4-97D2-D449-A50E-88DB8797BFD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031" r="93603" b="9795"/>
          <a:stretch/>
        </p:blipFill>
        <p:spPr>
          <a:xfrm>
            <a:off x="1574591" y="1413012"/>
            <a:ext cx="466462" cy="4831136"/>
          </a:xfrm>
          <a:prstGeom prst="rect">
            <a:avLst/>
          </a:prstGeom>
        </p:spPr>
      </p:pic>
      <p:sp>
        <p:nvSpPr>
          <p:cNvPr id="16" name="Freeform 15">
            <a:extLst>
              <a:ext uri="{FF2B5EF4-FFF2-40B4-BE49-F238E27FC236}">
                <a16:creationId xmlns:a16="http://schemas.microsoft.com/office/drawing/2014/main" id="{04541001-9C0D-2049-8AC7-0E3356C56F92}"/>
              </a:ext>
            </a:extLst>
          </p:cNvPr>
          <p:cNvSpPr/>
          <p:nvPr/>
        </p:nvSpPr>
        <p:spPr>
          <a:xfrm>
            <a:off x="2329018" y="4280843"/>
            <a:ext cx="2375555" cy="1357459"/>
          </a:xfrm>
          <a:custGeom>
            <a:avLst/>
            <a:gdLst>
              <a:gd name="connsiteX0" fmla="*/ 1734532 w 2375555"/>
              <a:gd name="connsiteY0" fmla="*/ 0 h 1357459"/>
              <a:gd name="connsiteX1" fmla="*/ 1809946 w 2375555"/>
              <a:gd name="connsiteY1" fmla="*/ 47134 h 1357459"/>
              <a:gd name="connsiteX2" fmla="*/ 1875934 w 2375555"/>
              <a:gd name="connsiteY2" fmla="*/ 37707 h 1357459"/>
              <a:gd name="connsiteX3" fmla="*/ 1989056 w 2375555"/>
              <a:gd name="connsiteY3" fmla="*/ 65987 h 1357459"/>
              <a:gd name="connsiteX4" fmla="*/ 2026763 w 2375555"/>
              <a:gd name="connsiteY4" fmla="*/ 122548 h 1357459"/>
              <a:gd name="connsiteX5" fmla="*/ 2055043 w 2375555"/>
              <a:gd name="connsiteY5" fmla="*/ 179109 h 1357459"/>
              <a:gd name="connsiteX6" fmla="*/ 2111604 w 2375555"/>
              <a:gd name="connsiteY6" fmla="*/ 292231 h 1357459"/>
              <a:gd name="connsiteX7" fmla="*/ 2139885 w 2375555"/>
              <a:gd name="connsiteY7" fmla="*/ 311084 h 1357459"/>
              <a:gd name="connsiteX8" fmla="*/ 2196445 w 2375555"/>
              <a:gd name="connsiteY8" fmla="*/ 329938 h 1357459"/>
              <a:gd name="connsiteX9" fmla="*/ 2224726 w 2375555"/>
              <a:gd name="connsiteY9" fmla="*/ 348791 h 1357459"/>
              <a:gd name="connsiteX10" fmla="*/ 2281287 w 2375555"/>
              <a:gd name="connsiteY10" fmla="*/ 377072 h 1357459"/>
              <a:gd name="connsiteX11" fmla="*/ 2347274 w 2375555"/>
              <a:gd name="connsiteY11" fmla="*/ 461913 h 1357459"/>
              <a:gd name="connsiteX12" fmla="*/ 2366128 w 2375555"/>
              <a:gd name="connsiteY12" fmla="*/ 518474 h 1357459"/>
              <a:gd name="connsiteX13" fmla="*/ 2375555 w 2375555"/>
              <a:gd name="connsiteY13" fmla="*/ 546754 h 1357459"/>
              <a:gd name="connsiteX14" fmla="*/ 2375555 w 2375555"/>
              <a:gd name="connsiteY14" fmla="*/ 716437 h 1357459"/>
              <a:gd name="connsiteX15" fmla="*/ 2366128 w 2375555"/>
              <a:gd name="connsiteY15" fmla="*/ 782424 h 1357459"/>
              <a:gd name="connsiteX16" fmla="*/ 2356701 w 2375555"/>
              <a:gd name="connsiteY16" fmla="*/ 810705 h 1357459"/>
              <a:gd name="connsiteX17" fmla="*/ 2300140 w 2375555"/>
              <a:gd name="connsiteY17" fmla="*/ 848412 h 1357459"/>
              <a:gd name="connsiteX18" fmla="*/ 2271860 w 2375555"/>
              <a:gd name="connsiteY18" fmla="*/ 867266 h 1357459"/>
              <a:gd name="connsiteX19" fmla="*/ 2205872 w 2375555"/>
              <a:gd name="connsiteY19" fmla="*/ 886119 h 1357459"/>
              <a:gd name="connsiteX20" fmla="*/ 1998483 w 2375555"/>
              <a:gd name="connsiteY20" fmla="*/ 857839 h 1357459"/>
              <a:gd name="connsiteX21" fmla="*/ 1923068 w 2375555"/>
              <a:gd name="connsiteY21" fmla="*/ 838985 h 1357459"/>
              <a:gd name="connsiteX22" fmla="*/ 1743959 w 2375555"/>
              <a:gd name="connsiteY22" fmla="*/ 848412 h 1357459"/>
              <a:gd name="connsiteX23" fmla="*/ 1659118 w 2375555"/>
              <a:gd name="connsiteY23" fmla="*/ 886119 h 1357459"/>
              <a:gd name="connsiteX24" fmla="*/ 1602557 w 2375555"/>
              <a:gd name="connsiteY24" fmla="*/ 923826 h 1357459"/>
              <a:gd name="connsiteX25" fmla="*/ 1545996 w 2375555"/>
              <a:gd name="connsiteY25" fmla="*/ 961534 h 1357459"/>
              <a:gd name="connsiteX26" fmla="*/ 1517716 w 2375555"/>
              <a:gd name="connsiteY26" fmla="*/ 980387 h 1357459"/>
              <a:gd name="connsiteX27" fmla="*/ 1461155 w 2375555"/>
              <a:gd name="connsiteY27" fmla="*/ 999241 h 1357459"/>
              <a:gd name="connsiteX28" fmla="*/ 1310326 w 2375555"/>
              <a:gd name="connsiteY28" fmla="*/ 989814 h 1357459"/>
              <a:gd name="connsiteX29" fmla="*/ 1282045 w 2375555"/>
              <a:gd name="connsiteY29" fmla="*/ 970960 h 1357459"/>
              <a:gd name="connsiteX30" fmla="*/ 1187777 w 2375555"/>
              <a:gd name="connsiteY30" fmla="*/ 942680 h 1357459"/>
              <a:gd name="connsiteX31" fmla="*/ 933254 w 2375555"/>
              <a:gd name="connsiteY31" fmla="*/ 952107 h 1357459"/>
              <a:gd name="connsiteX32" fmla="*/ 895546 w 2375555"/>
              <a:gd name="connsiteY32" fmla="*/ 961534 h 1357459"/>
              <a:gd name="connsiteX33" fmla="*/ 838986 w 2375555"/>
              <a:gd name="connsiteY33" fmla="*/ 989814 h 1357459"/>
              <a:gd name="connsiteX34" fmla="*/ 782425 w 2375555"/>
              <a:gd name="connsiteY34" fmla="*/ 1046375 h 1357459"/>
              <a:gd name="connsiteX35" fmla="*/ 754144 w 2375555"/>
              <a:gd name="connsiteY35" fmla="*/ 1065229 h 1357459"/>
              <a:gd name="connsiteX36" fmla="*/ 725864 w 2375555"/>
              <a:gd name="connsiteY36" fmla="*/ 1093509 h 1357459"/>
              <a:gd name="connsiteX37" fmla="*/ 669303 w 2375555"/>
              <a:gd name="connsiteY37" fmla="*/ 1131216 h 1357459"/>
              <a:gd name="connsiteX38" fmla="*/ 641023 w 2375555"/>
              <a:gd name="connsiteY38" fmla="*/ 1150070 h 1357459"/>
              <a:gd name="connsiteX39" fmla="*/ 593889 w 2375555"/>
              <a:gd name="connsiteY39" fmla="*/ 1206631 h 1357459"/>
              <a:gd name="connsiteX40" fmla="*/ 584462 w 2375555"/>
              <a:gd name="connsiteY40" fmla="*/ 1234911 h 1357459"/>
              <a:gd name="connsiteX41" fmla="*/ 556182 w 2375555"/>
              <a:gd name="connsiteY41" fmla="*/ 1263191 h 1357459"/>
              <a:gd name="connsiteX42" fmla="*/ 537328 w 2375555"/>
              <a:gd name="connsiteY42" fmla="*/ 1291472 h 1357459"/>
              <a:gd name="connsiteX43" fmla="*/ 480767 w 2375555"/>
              <a:gd name="connsiteY43" fmla="*/ 1310325 h 1357459"/>
              <a:gd name="connsiteX44" fmla="*/ 452487 w 2375555"/>
              <a:gd name="connsiteY44" fmla="*/ 1319752 h 1357459"/>
              <a:gd name="connsiteX45" fmla="*/ 424206 w 2375555"/>
              <a:gd name="connsiteY45" fmla="*/ 1338606 h 1357459"/>
              <a:gd name="connsiteX46" fmla="*/ 358219 w 2375555"/>
              <a:gd name="connsiteY46" fmla="*/ 1357459 h 1357459"/>
              <a:gd name="connsiteX47" fmla="*/ 245097 w 2375555"/>
              <a:gd name="connsiteY47" fmla="*/ 1348033 h 1357459"/>
              <a:gd name="connsiteX48" fmla="*/ 216817 w 2375555"/>
              <a:gd name="connsiteY48" fmla="*/ 1338606 h 1357459"/>
              <a:gd name="connsiteX49" fmla="*/ 188536 w 2375555"/>
              <a:gd name="connsiteY49" fmla="*/ 1310325 h 1357459"/>
              <a:gd name="connsiteX50" fmla="*/ 103695 w 2375555"/>
              <a:gd name="connsiteY50" fmla="*/ 1253765 h 1357459"/>
              <a:gd name="connsiteX51" fmla="*/ 75414 w 2375555"/>
              <a:gd name="connsiteY51" fmla="*/ 1234911 h 1357459"/>
              <a:gd name="connsiteX52" fmla="*/ 18854 w 2375555"/>
              <a:gd name="connsiteY52" fmla="*/ 1121789 h 1357459"/>
              <a:gd name="connsiteX53" fmla="*/ 9427 w 2375555"/>
              <a:gd name="connsiteY53" fmla="*/ 1093509 h 1357459"/>
              <a:gd name="connsiteX54" fmla="*/ 0 w 2375555"/>
              <a:gd name="connsiteY54" fmla="*/ 829558 h 1357459"/>
              <a:gd name="connsiteX55" fmla="*/ 9427 w 2375555"/>
              <a:gd name="connsiteY55" fmla="*/ 622169 h 1357459"/>
              <a:gd name="connsiteX56" fmla="*/ 28280 w 2375555"/>
              <a:gd name="connsiteY56" fmla="*/ 565608 h 1357459"/>
              <a:gd name="connsiteX57" fmla="*/ 47134 w 2375555"/>
              <a:gd name="connsiteY57" fmla="*/ 537328 h 1357459"/>
              <a:gd name="connsiteX58" fmla="*/ 75414 w 2375555"/>
              <a:gd name="connsiteY58" fmla="*/ 480767 h 1357459"/>
              <a:gd name="connsiteX59" fmla="*/ 84841 w 2375555"/>
              <a:gd name="connsiteY59" fmla="*/ 452486 h 1357459"/>
              <a:gd name="connsiteX60" fmla="*/ 113122 w 2375555"/>
              <a:gd name="connsiteY60" fmla="*/ 433633 h 1357459"/>
              <a:gd name="connsiteX61" fmla="*/ 131975 w 2375555"/>
              <a:gd name="connsiteY61" fmla="*/ 405352 h 1357459"/>
              <a:gd name="connsiteX62" fmla="*/ 188536 w 2375555"/>
              <a:gd name="connsiteY62" fmla="*/ 367645 h 1357459"/>
              <a:gd name="connsiteX63" fmla="*/ 216817 w 2375555"/>
              <a:gd name="connsiteY63" fmla="*/ 282804 h 1357459"/>
              <a:gd name="connsiteX64" fmla="*/ 226243 w 2375555"/>
              <a:gd name="connsiteY64" fmla="*/ 254523 h 1357459"/>
              <a:gd name="connsiteX65" fmla="*/ 282804 w 2375555"/>
              <a:gd name="connsiteY65" fmla="*/ 207389 h 1357459"/>
              <a:gd name="connsiteX66" fmla="*/ 311085 w 2375555"/>
              <a:gd name="connsiteY66" fmla="*/ 179109 h 1357459"/>
              <a:gd name="connsiteX67" fmla="*/ 367645 w 2375555"/>
              <a:gd name="connsiteY67" fmla="*/ 160255 h 1357459"/>
              <a:gd name="connsiteX68" fmla="*/ 405353 w 2375555"/>
              <a:gd name="connsiteY68" fmla="*/ 150829 h 1357459"/>
              <a:gd name="connsiteX69" fmla="*/ 490194 w 2375555"/>
              <a:gd name="connsiteY69" fmla="*/ 131975 h 1357459"/>
              <a:gd name="connsiteX70" fmla="*/ 546755 w 2375555"/>
              <a:gd name="connsiteY70" fmla="*/ 113121 h 1357459"/>
              <a:gd name="connsiteX71" fmla="*/ 622169 w 2375555"/>
              <a:gd name="connsiteY71" fmla="*/ 113121 h 1357459"/>
              <a:gd name="connsiteX72" fmla="*/ 678730 w 2375555"/>
              <a:gd name="connsiteY72" fmla="*/ 94268 h 135745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</a:cxnLst>
            <a:rect l="l" t="t" r="r" b="b"/>
            <a:pathLst>
              <a:path w="2375555" h="1357459">
                <a:moveTo>
                  <a:pt x="1734532" y="0"/>
                </a:moveTo>
                <a:cubicBezTo>
                  <a:pt x="1749460" y="11942"/>
                  <a:pt x="1782316" y="47134"/>
                  <a:pt x="1809946" y="47134"/>
                </a:cubicBezTo>
                <a:cubicBezTo>
                  <a:pt x="1832165" y="47134"/>
                  <a:pt x="1853938" y="40849"/>
                  <a:pt x="1875934" y="37707"/>
                </a:cubicBezTo>
                <a:cubicBezTo>
                  <a:pt x="1911806" y="41693"/>
                  <a:pt x="1961081" y="34016"/>
                  <a:pt x="1989056" y="65987"/>
                </a:cubicBezTo>
                <a:cubicBezTo>
                  <a:pt x="2003977" y="83040"/>
                  <a:pt x="2026763" y="122548"/>
                  <a:pt x="2026763" y="122548"/>
                </a:cubicBezTo>
                <a:cubicBezTo>
                  <a:pt x="2061143" y="225687"/>
                  <a:pt x="2006314" y="69467"/>
                  <a:pt x="2055043" y="179109"/>
                </a:cubicBezTo>
                <a:cubicBezTo>
                  <a:pt x="2070891" y="214767"/>
                  <a:pt x="2074471" y="267477"/>
                  <a:pt x="2111604" y="292231"/>
                </a:cubicBezTo>
                <a:cubicBezTo>
                  <a:pt x="2121031" y="298515"/>
                  <a:pt x="2129532" y="306483"/>
                  <a:pt x="2139885" y="311084"/>
                </a:cubicBezTo>
                <a:cubicBezTo>
                  <a:pt x="2158045" y="319155"/>
                  <a:pt x="2179909" y="318915"/>
                  <a:pt x="2196445" y="329938"/>
                </a:cubicBezTo>
                <a:cubicBezTo>
                  <a:pt x="2205872" y="336222"/>
                  <a:pt x="2214592" y="343724"/>
                  <a:pt x="2224726" y="348791"/>
                </a:cubicBezTo>
                <a:cubicBezTo>
                  <a:pt x="2267239" y="370047"/>
                  <a:pt x="2240765" y="343304"/>
                  <a:pt x="2281287" y="377072"/>
                </a:cubicBezTo>
                <a:cubicBezTo>
                  <a:pt x="2303811" y="395842"/>
                  <a:pt x="2339188" y="437657"/>
                  <a:pt x="2347274" y="461913"/>
                </a:cubicBezTo>
                <a:lnTo>
                  <a:pt x="2366128" y="518474"/>
                </a:lnTo>
                <a:lnTo>
                  <a:pt x="2375555" y="546754"/>
                </a:lnTo>
                <a:cubicBezTo>
                  <a:pt x="2352626" y="730183"/>
                  <a:pt x="2375555" y="501379"/>
                  <a:pt x="2375555" y="716437"/>
                </a:cubicBezTo>
                <a:cubicBezTo>
                  <a:pt x="2375555" y="738656"/>
                  <a:pt x="2370486" y="760637"/>
                  <a:pt x="2366128" y="782424"/>
                </a:cubicBezTo>
                <a:cubicBezTo>
                  <a:pt x="2364179" y="792168"/>
                  <a:pt x="2363727" y="803679"/>
                  <a:pt x="2356701" y="810705"/>
                </a:cubicBezTo>
                <a:cubicBezTo>
                  <a:pt x="2340679" y="826727"/>
                  <a:pt x="2318994" y="835843"/>
                  <a:pt x="2300140" y="848412"/>
                </a:cubicBezTo>
                <a:cubicBezTo>
                  <a:pt x="2290713" y="854697"/>
                  <a:pt x="2282608" y="863684"/>
                  <a:pt x="2271860" y="867266"/>
                </a:cubicBezTo>
                <a:cubicBezTo>
                  <a:pt x="2231288" y="880789"/>
                  <a:pt x="2253219" y="874282"/>
                  <a:pt x="2205872" y="886119"/>
                </a:cubicBezTo>
                <a:cubicBezTo>
                  <a:pt x="1917665" y="868106"/>
                  <a:pt x="2149204" y="895520"/>
                  <a:pt x="1998483" y="857839"/>
                </a:cubicBezTo>
                <a:lnTo>
                  <a:pt x="1923068" y="838985"/>
                </a:lnTo>
                <a:cubicBezTo>
                  <a:pt x="1863365" y="842127"/>
                  <a:pt x="1803319" y="841289"/>
                  <a:pt x="1743959" y="848412"/>
                </a:cubicBezTo>
                <a:cubicBezTo>
                  <a:pt x="1715149" y="851869"/>
                  <a:pt x="1681987" y="867062"/>
                  <a:pt x="1659118" y="886119"/>
                </a:cubicBezTo>
                <a:cubicBezTo>
                  <a:pt x="1612042" y="925349"/>
                  <a:pt x="1652256" y="907261"/>
                  <a:pt x="1602557" y="923826"/>
                </a:cubicBezTo>
                <a:lnTo>
                  <a:pt x="1545996" y="961534"/>
                </a:lnTo>
                <a:cubicBezTo>
                  <a:pt x="1536569" y="967818"/>
                  <a:pt x="1528464" y="976804"/>
                  <a:pt x="1517716" y="980387"/>
                </a:cubicBezTo>
                <a:lnTo>
                  <a:pt x="1461155" y="999241"/>
                </a:lnTo>
                <a:cubicBezTo>
                  <a:pt x="1410879" y="996099"/>
                  <a:pt x="1360084" y="997671"/>
                  <a:pt x="1310326" y="989814"/>
                </a:cubicBezTo>
                <a:cubicBezTo>
                  <a:pt x="1299135" y="988047"/>
                  <a:pt x="1292398" y="975561"/>
                  <a:pt x="1282045" y="970960"/>
                </a:cubicBezTo>
                <a:cubicBezTo>
                  <a:pt x="1252539" y="957846"/>
                  <a:pt x="1219114" y="950514"/>
                  <a:pt x="1187777" y="942680"/>
                </a:cubicBezTo>
                <a:cubicBezTo>
                  <a:pt x="1102936" y="945822"/>
                  <a:pt x="1017977" y="946641"/>
                  <a:pt x="933254" y="952107"/>
                </a:cubicBezTo>
                <a:cubicBezTo>
                  <a:pt x="920325" y="952941"/>
                  <a:pt x="907455" y="956430"/>
                  <a:pt x="895546" y="961534"/>
                </a:cubicBezTo>
                <a:cubicBezTo>
                  <a:pt x="767610" y="1016362"/>
                  <a:pt x="958167" y="950086"/>
                  <a:pt x="838986" y="989814"/>
                </a:cubicBezTo>
                <a:cubicBezTo>
                  <a:pt x="820132" y="1008668"/>
                  <a:pt x="804610" y="1031585"/>
                  <a:pt x="782425" y="1046375"/>
                </a:cubicBezTo>
                <a:cubicBezTo>
                  <a:pt x="772998" y="1052660"/>
                  <a:pt x="762848" y="1057976"/>
                  <a:pt x="754144" y="1065229"/>
                </a:cubicBezTo>
                <a:cubicBezTo>
                  <a:pt x="743903" y="1073763"/>
                  <a:pt x="736387" y="1085324"/>
                  <a:pt x="725864" y="1093509"/>
                </a:cubicBezTo>
                <a:cubicBezTo>
                  <a:pt x="707978" y="1107420"/>
                  <a:pt x="688157" y="1118647"/>
                  <a:pt x="669303" y="1131216"/>
                </a:cubicBezTo>
                <a:cubicBezTo>
                  <a:pt x="659876" y="1137501"/>
                  <a:pt x="649034" y="1142059"/>
                  <a:pt x="641023" y="1150070"/>
                </a:cubicBezTo>
                <a:cubicBezTo>
                  <a:pt x="620171" y="1170921"/>
                  <a:pt x="607015" y="1180379"/>
                  <a:pt x="593889" y="1206631"/>
                </a:cubicBezTo>
                <a:cubicBezTo>
                  <a:pt x="589445" y="1215519"/>
                  <a:pt x="589974" y="1226643"/>
                  <a:pt x="584462" y="1234911"/>
                </a:cubicBezTo>
                <a:cubicBezTo>
                  <a:pt x="577067" y="1246003"/>
                  <a:pt x="564716" y="1252950"/>
                  <a:pt x="556182" y="1263191"/>
                </a:cubicBezTo>
                <a:cubicBezTo>
                  <a:pt x="548929" y="1271895"/>
                  <a:pt x="546936" y="1285467"/>
                  <a:pt x="537328" y="1291472"/>
                </a:cubicBezTo>
                <a:cubicBezTo>
                  <a:pt x="520475" y="1302005"/>
                  <a:pt x="499621" y="1304041"/>
                  <a:pt x="480767" y="1310325"/>
                </a:cubicBezTo>
                <a:cubicBezTo>
                  <a:pt x="471340" y="1313467"/>
                  <a:pt x="460755" y="1314240"/>
                  <a:pt x="452487" y="1319752"/>
                </a:cubicBezTo>
                <a:cubicBezTo>
                  <a:pt x="443060" y="1326037"/>
                  <a:pt x="434340" y="1333539"/>
                  <a:pt x="424206" y="1338606"/>
                </a:cubicBezTo>
                <a:cubicBezTo>
                  <a:pt x="410679" y="1345370"/>
                  <a:pt x="370305" y="1354438"/>
                  <a:pt x="358219" y="1357459"/>
                </a:cubicBezTo>
                <a:cubicBezTo>
                  <a:pt x="320512" y="1354317"/>
                  <a:pt x="282603" y="1353034"/>
                  <a:pt x="245097" y="1348033"/>
                </a:cubicBezTo>
                <a:cubicBezTo>
                  <a:pt x="235248" y="1346720"/>
                  <a:pt x="225085" y="1344118"/>
                  <a:pt x="216817" y="1338606"/>
                </a:cubicBezTo>
                <a:cubicBezTo>
                  <a:pt x="205724" y="1331211"/>
                  <a:pt x="199059" y="1318510"/>
                  <a:pt x="188536" y="1310325"/>
                </a:cubicBezTo>
                <a:cubicBezTo>
                  <a:pt x="188531" y="1310321"/>
                  <a:pt x="117838" y="1263194"/>
                  <a:pt x="103695" y="1253765"/>
                </a:cubicBezTo>
                <a:lnTo>
                  <a:pt x="75414" y="1234911"/>
                </a:lnTo>
                <a:cubicBezTo>
                  <a:pt x="26682" y="1161812"/>
                  <a:pt x="44873" y="1199848"/>
                  <a:pt x="18854" y="1121789"/>
                </a:cubicBezTo>
                <a:lnTo>
                  <a:pt x="9427" y="1093509"/>
                </a:lnTo>
                <a:cubicBezTo>
                  <a:pt x="6285" y="1005525"/>
                  <a:pt x="0" y="917598"/>
                  <a:pt x="0" y="829558"/>
                </a:cubicBezTo>
                <a:cubicBezTo>
                  <a:pt x="0" y="760357"/>
                  <a:pt x="2055" y="690976"/>
                  <a:pt x="9427" y="622169"/>
                </a:cubicBezTo>
                <a:cubicBezTo>
                  <a:pt x="11544" y="602409"/>
                  <a:pt x="17256" y="582144"/>
                  <a:pt x="28280" y="565608"/>
                </a:cubicBezTo>
                <a:lnTo>
                  <a:pt x="47134" y="537328"/>
                </a:lnTo>
                <a:cubicBezTo>
                  <a:pt x="70829" y="466242"/>
                  <a:pt x="38866" y="553864"/>
                  <a:pt x="75414" y="480767"/>
                </a:cubicBezTo>
                <a:cubicBezTo>
                  <a:pt x="79858" y="471879"/>
                  <a:pt x="78633" y="460245"/>
                  <a:pt x="84841" y="452486"/>
                </a:cubicBezTo>
                <a:cubicBezTo>
                  <a:pt x="91919" y="443639"/>
                  <a:pt x="103695" y="439917"/>
                  <a:pt x="113122" y="433633"/>
                </a:cubicBezTo>
                <a:cubicBezTo>
                  <a:pt x="119406" y="424206"/>
                  <a:pt x="123449" y="412813"/>
                  <a:pt x="131975" y="405352"/>
                </a:cubicBezTo>
                <a:cubicBezTo>
                  <a:pt x="149028" y="390431"/>
                  <a:pt x="188536" y="367645"/>
                  <a:pt x="188536" y="367645"/>
                </a:cubicBezTo>
                <a:lnTo>
                  <a:pt x="216817" y="282804"/>
                </a:lnTo>
                <a:cubicBezTo>
                  <a:pt x="219959" y="273377"/>
                  <a:pt x="219216" y="261549"/>
                  <a:pt x="226243" y="254523"/>
                </a:cubicBezTo>
                <a:cubicBezTo>
                  <a:pt x="308867" y="171902"/>
                  <a:pt x="204058" y="273011"/>
                  <a:pt x="282804" y="207389"/>
                </a:cubicBezTo>
                <a:cubicBezTo>
                  <a:pt x="293046" y="198854"/>
                  <a:pt x="299431" y="185583"/>
                  <a:pt x="311085" y="179109"/>
                </a:cubicBezTo>
                <a:cubicBezTo>
                  <a:pt x="328457" y="169458"/>
                  <a:pt x="348365" y="165074"/>
                  <a:pt x="367645" y="160255"/>
                </a:cubicBezTo>
                <a:cubicBezTo>
                  <a:pt x="380214" y="157113"/>
                  <a:pt x="392705" y="153639"/>
                  <a:pt x="405353" y="150829"/>
                </a:cubicBezTo>
                <a:cubicBezTo>
                  <a:pt x="439947" y="143142"/>
                  <a:pt x="457355" y="141827"/>
                  <a:pt x="490194" y="131975"/>
                </a:cubicBezTo>
                <a:cubicBezTo>
                  <a:pt x="509229" y="126264"/>
                  <a:pt x="546755" y="113121"/>
                  <a:pt x="546755" y="113121"/>
                </a:cubicBezTo>
                <a:cubicBezTo>
                  <a:pt x="586003" y="126204"/>
                  <a:pt x="572116" y="126772"/>
                  <a:pt x="622169" y="113121"/>
                </a:cubicBezTo>
                <a:cubicBezTo>
                  <a:pt x="641342" y="107892"/>
                  <a:pt x="678730" y="94268"/>
                  <a:pt x="678730" y="94268"/>
                </a:cubicBezTo>
              </a:path>
            </a:pathLst>
          </a:cu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638C0E8-304C-3A4E-BBEE-87FC75299FFD}"/>
              </a:ext>
            </a:extLst>
          </p:cNvPr>
          <p:cNvCxnSpPr/>
          <p:nvPr/>
        </p:nvCxnSpPr>
        <p:spPr>
          <a:xfrm flipV="1">
            <a:off x="2913476" y="4346832"/>
            <a:ext cx="160256" cy="58506"/>
          </a:xfrm>
          <a:prstGeom prst="straightConnector1">
            <a:avLst/>
          </a:prstGeom>
          <a:ln w="53975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Freeform 19">
            <a:extLst>
              <a:ext uri="{FF2B5EF4-FFF2-40B4-BE49-F238E27FC236}">
                <a16:creationId xmlns:a16="http://schemas.microsoft.com/office/drawing/2014/main" id="{D667294C-F6B6-3943-AEA8-86D83F80F0AA}"/>
              </a:ext>
            </a:extLst>
          </p:cNvPr>
          <p:cNvSpPr/>
          <p:nvPr/>
        </p:nvSpPr>
        <p:spPr>
          <a:xfrm>
            <a:off x="3073736" y="4261989"/>
            <a:ext cx="952107" cy="150829"/>
          </a:xfrm>
          <a:custGeom>
            <a:avLst/>
            <a:gdLst>
              <a:gd name="connsiteX0" fmla="*/ 0 w 952107"/>
              <a:gd name="connsiteY0" fmla="*/ 103695 h 150829"/>
              <a:gd name="connsiteX1" fmla="*/ 65987 w 952107"/>
              <a:gd name="connsiteY1" fmla="*/ 94268 h 150829"/>
              <a:gd name="connsiteX2" fmla="*/ 122548 w 952107"/>
              <a:gd name="connsiteY2" fmla="*/ 75414 h 150829"/>
              <a:gd name="connsiteX3" fmla="*/ 150828 w 952107"/>
              <a:gd name="connsiteY3" fmla="*/ 65988 h 150829"/>
              <a:gd name="connsiteX4" fmla="*/ 179109 w 952107"/>
              <a:gd name="connsiteY4" fmla="*/ 84841 h 150829"/>
              <a:gd name="connsiteX5" fmla="*/ 207389 w 952107"/>
              <a:gd name="connsiteY5" fmla="*/ 141402 h 150829"/>
              <a:gd name="connsiteX6" fmla="*/ 235670 w 952107"/>
              <a:gd name="connsiteY6" fmla="*/ 150829 h 150829"/>
              <a:gd name="connsiteX7" fmla="*/ 292231 w 952107"/>
              <a:gd name="connsiteY7" fmla="*/ 141402 h 150829"/>
              <a:gd name="connsiteX8" fmla="*/ 329938 w 952107"/>
              <a:gd name="connsiteY8" fmla="*/ 84841 h 150829"/>
              <a:gd name="connsiteX9" fmla="*/ 386499 w 952107"/>
              <a:gd name="connsiteY9" fmla="*/ 37707 h 150829"/>
              <a:gd name="connsiteX10" fmla="*/ 414779 w 952107"/>
              <a:gd name="connsiteY10" fmla="*/ 28280 h 150829"/>
              <a:gd name="connsiteX11" fmla="*/ 480767 w 952107"/>
              <a:gd name="connsiteY11" fmla="*/ 37707 h 150829"/>
              <a:gd name="connsiteX12" fmla="*/ 527901 w 952107"/>
              <a:gd name="connsiteY12" fmla="*/ 84841 h 150829"/>
              <a:gd name="connsiteX13" fmla="*/ 584461 w 952107"/>
              <a:gd name="connsiteY13" fmla="*/ 113122 h 150829"/>
              <a:gd name="connsiteX14" fmla="*/ 678729 w 952107"/>
              <a:gd name="connsiteY14" fmla="*/ 103695 h 150829"/>
              <a:gd name="connsiteX15" fmla="*/ 697583 w 952107"/>
              <a:gd name="connsiteY15" fmla="*/ 75414 h 150829"/>
              <a:gd name="connsiteX16" fmla="*/ 725864 w 952107"/>
              <a:gd name="connsiteY16" fmla="*/ 47134 h 150829"/>
              <a:gd name="connsiteX17" fmla="*/ 810705 w 952107"/>
              <a:gd name="connsiteY17" fmla="*/ 0 h 150829"/>
              <a:gd name="connsiteX18" fmla="*/ 895546 w 952107"/>
              <a:gd name="connsiteY18" fmla="*/ 9427 h 150829"/>
              <a:gd name="connsiteX19" fmla="*/ 923826 w 952107"/>
              <a:gd name="connsiteY19" fmla="*/ 18854 h 150829"/>
              <a:gd name="connsiteX20" fmla="*/ 952107 w 952107"/>
              <a:gd name="connsiteY20" fmla="*/ 37707 h 150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952107" h="150829">
                <a:moveTo>
                  <a:pt x="0" y="103695"/>
                </a:moveTo>
                <a:cubicBezTo>
                  <a:pt x="93660" y="141160"/>
                  <a:pt x="13640" y="126986"/>
                  <a:pt x="65987" y="94268"/>
                </a:cubicBezTo>
                <a:cubicBezTo>
                  <a:pt x="82840" y="83735"/>
                  <a:pt x="103694" y="81698"/>
                  <a:pt x="122548" y="75414"/>
                </a:cubicBezTo>
                <a:lnTo>
                  <a:pt x="150828" y="65988"/>
                </a:lnTo>
                <a:cubicBezTo>
                  <a:pt x="160255" y="72272"/>
                  <a:pt x="172031" y="75994"/>
                  <a:pt x="179109" y="84841"/>
                </a:cubicBezTo>
                <a:cubicBezTo>
                  <a:pt x="209469" y="122790"/>
                  <a:pt x="163242" y="106085"/>
                  <a:pt x="207389" y="141402"/>
                </a:cubicBezTo>
                <a:cubicBezTo>
                  <a:pt x="215148" y="147610"/>
                  <a:pt x="226243" y="147687"/>
                  <a:pt x="235670" y="150829"/>
                </a:cubicBezTo>
                <a:cubicBezTo>
                  <a:pt x="254524" y="147687"/>
                  <a:pt x="276572" y="152363"/>
                  <a:pt x="292231" y="141402"/>
                </a:cubicBezTo>
                <a:cubicBezTo>
                  <a:pt x="310794" y="128408"/>
                  <a:pt x="313916" y="100863"/>
                  <a:pt x="329938" y="84841"/>
                </a:cubicBezTo>
                <a:cubicBezTo>
                  <a:pt x="350787" y="63992"/>
                  <a:pt x="360250" y="50832"/>
                  <a:pt x="386499" y="37707"/>
                </a:cubicBezTo>
                <a:cubicBezTo>
                  <a:pt x="395387" y="33263"/>
                  <a:pt x="405352" y="31422"/>
                  <a:pt x="414779" y="28280"/>
                </a:cubicBezTo>
                <a:cubicBezTo>
                  <a:pt x="436775" y="31422"/>
                  <a:pt x="459485" y="31322"/>
                  <a:pt x="480767" y="37707"/>
                </a:cubicBezTo>
                <a:cubicBezTo>
                  <a:pt x="516676" y="48480"/>
                  <a:pt x="504560" y="61500"/>
                  <a:pt x="527901" y="84841"/>
                </a:cubicBezTo>
                <a:cubicBezTo>
                  <a:pt x="546176" y="103116"/>
                  <a:pt x="561459" y="105454"/>
                  <a:pt x="584461" y="113122"/>
                </a:cubicBezTo>
                <a:cubicBezTo>
                  <a:pt x="615884" y="109980"/>
                  <a:pt x="648770" y="113681"/>
                  <a:pt x="678729" y="103695"/>
                </a:cubicBezTo>
                <a:cubicBezTo>
                  <a:pt x="689477" y="100112"/>
                  <a:pt x="690330" y="84118"/>
                  <a:pt x="697583" y="75414"/>
                </a:cubicBezTo>
                <a:cubicBezTo>
                  <a:pt x="706118" y="65172"/>
                  <a:pt x="715341" y="55319"/>
                  <a:pt x="725864" y="47134"/>
                </a:cubicBezTo>
                <a:cubicBezTo>
                  <a:pt x="774486" y="9317"/>
                  <a:pt x="768035" y="14223"/>
                  <a:pt x="810705" y="0"/>
                </a:cubicBezTo>
                <a:cubicBezTo>
                  <a:pt x="838985" y="3142"/>
                  <a:pt x="867479" y="4749"/>
                  <a:pt x="895546" y="9427"/>
                </a:cubicBezTo>
                <a:cubicBezTo>
                  <a:pt x="905347" y="11061"/>
                  <a:pt x="914938" y="14410"/>
                  <a:pt x="923826" y="18854"/>
                </a:cubicBezTo>
                <a:cubicBezTo>
                  <a:pt x="933960" y="23921"/>
                  <a:pt x="952107" y="37707"/>
                  <a:pt x="952107" y="37707"/>
                </a:cubicBezTo>
              </a:path>
            </a:pathLst>
          </a:custGeom>
          <a:noFill/>
          <a:ln w="635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4D13DE0F-2584-5142-8A29-D59765CEDB78}"/>
              </a:ext>
            </a:extLst>
          </p:cNvPr>
          <p:cNvCxnSpPr>
            <a:cxnSpLocks/>
          </p:cNvCxnSpPr>
          <p:nvPr/>
        </p:nvCxnSpPr>
        <p:spPr>
          <a:xfrm>
            <a:off x="3978548" y="4282251"/>
            <a:ext cx="90257" cy="1435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itle 1">
            <a:extLst>
              <a:ext uri="{FF2B5EF4-FFF2-40B4-BE49-F238E27FC236}">
                <a16:creationId xmlns:a16="http://schemas.microsoft.com/office/drawing/2014/main" id="{3A2D34D4-213B-2C42-98D5-92E3AD256CBE}"/>
              </a:ext>
            </a:extLst>
          </p:cNvPr>
          <p:cNvSpPr txBox="1">
            <a:spLocks/>
          </p:cNvSpPr>
          <p:nvPr/>
        </p:nvSpPr>
        <p:spPr>
          <a:xfrm>
            <a:off x="8579272" y="3058864"/>
            <a:ext cx="1053236" cy="4754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 Cloud</a:t>
            </a:r>
            <a:endParaRPr lang="en-US" sz="1600" dirty="0">
              <a:solidFill>
                <a:schemeClr val="bg1"/>
              </a:solidFill>
            </a:endParaRPr>
          </a:p>
        </p:txBody>
      </p:sp>
      <p:sp>
        <p:nvSpPr>
          <p:cNvPr id="7" name="Freeform 6">
            <a:extLst>
              <a:ext uri="{FF2B5EF4-FFF2-40B4-BE49-F238E27FC236}">
                <a16:creationId xmlns:a16="http://schemas.microsoft.com/office/drawing/2014/main" id="{ADD01267-B4D7-9746-B7D7-1CCC8B59364B}"/>
              </a:ext>
            </a:extLst>
          </p:cNvPr>
          <p:cNvSpPr/>
          <p:nvPr/>
        </p:nvSpPr>
        <p:spPr>
          <a:xfrm rot="21279737">
            <a:off x="8442112" y="4394907"/>
            <a:ext cx="969869" cy="210312"/>
          </a:xfrm>
          <a:custGeom>
            <a:avLst/>
            <a:gdLst>
              <a:gd name="connsiteX0" fmla="*/ 0 w 887573"/>
              <a:gd name="connsiteY0" fmla="*/ 228600 h 228600"/>
              <a:gd name="connsiteX1" fmla="*/ 45720 w 887573"/>
              <a:gd name="connsiteY1" fmla="*/ 192024 h 228600"/>
              <a:gd name="connsiteX2" fmla="*/ 82296 w 887573"/>
              <a:gd name="connsiteY2" fmla="*/ 137160 h 228600"/>
              <a:gd name="connsiteX3" fmla="*/ 164592 w 887573"/>
              <a:gd name="connsiteY3" fmla="*/ 73152 h 228600"/>
              <a:gd name="connsiteX4" fmla="*/ 192024 w 887573"/>
              <a:gd name="connsiteY4" fmla="*/ 64008 h 228600"/>
              <a:gd name="connsiteX5" fmla="*/ 310896 w 887573"/>
              <a:gd name="connsiteY5" fmla="*/ 73152 h 228600"/>
              <a:gd name="connsiteX6" fmla="*/ 365760 w 887573"/>
              <a:gd name="connsiteY6" fmla="*/ 91440 h 228600"/>
              <a:gd name="connsiteX7" fmla="*/ 393192 w 887573"/>
              <a:gd name="connsiteY7" fmla="*/ 100584 h 228600"/>
              <a:gd name="connsiteX8" fmla="*/ 548640 w 887573"/>
              <a:gd name="connsiteY8" fmla="*/ 82296 h 228600"/>
              <a:gd name="connsiteX9" fmla="*/ 576072 w 887573"/>
              <a:gd name="connsiteY9" fmla="*/ 64008 h 228600"/>
              <a:gd name="connsiteX10" fmla="*/ 621792 w 887573"/>
              <a:gd name="connsiteY10" fmla="*/ 18288 h 228600"/>
              <a:gd name="connsiteX11" fmla="*/ 676656 w 887573"/>
              <a:gd name="connsiteY11" fmla="*/ 0 h 228600"/>
              <a:gd name="connsiteX12" fmla="*/ 749808 w 887573"/>
              <a:gd name="connsiteY12" fmla="*/ 18288 h 228600"/>
              <a:gd name="connsiteX13" fmla="*/ 804672 w 887573"/>
              <a:gd name="connsiteY13" fmla="*/ 54864 h 228600"/>
              <a:gd name="connsiteX14" fmla="*/ 859536 w 887573"/>
              <a:gd name="connsiteY14" fmla="*/ 137160 h 228600"/>
              <a:gd name="connsiteX15" fmla="*/ 886968 w 887573"/>
              <a:gd name="connsiteY15" fmla="*/ 192024 h 228600"/>
              <a:gd name="connsiteX16" fmla="*/ 886968 w 887573"/>
              <a:gd name="connsiteY16" fmla="*/ 182880 h 228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887573" h="228600">
                <a:moveTo>
                  <a:pt x="0" y="228600"/>
                </a:moveTo>
                <a:cubicBezTo>
                  <a:pt x="15240" y="216408"/>
                  <a:pt x="32664" y="206531"/>
                  <a:pt x="45720" y="192024"/>
                </a:cubicBezTo>
                <a:cubicBezTo>
                  <a:pt x="60423" y="175687"/>
                  <a:pt x="66754" y="152702"/>
                  <a:pt x="82296" y="137160"/>
                </a:cubicBezTo>
                <a:cubicBezTo>
                  <a:pt x="105965" y="113491"/>
                  <a:pt x="131780" y="84089"/>
                  <a:pt x="164592" y="73152"/>
                </a:cubicBezTo>
                <a:lnTo>
                  <a:pt x="192024" y="64008"/>
                </a:lnTo>
                <a:cubicBezTo>
                  <a:pt x="231648" y="67056"/>
                  <a:pt x="271641" y="66954"/>
                  <a:pt x="310896" y="73152"/>
                </a:cubicBezTo>
                <a:cubicBezTo>
                  <a:pt x="329937" y="76159"/>
                  <a:pt x="347472" y="85344"/>
                  <a:pt x="365760" y="91440"/>
                </a:cubicBezTo>
                <a:lnTo>
                  <a:pt x="393192" y="100584"/>
                </a:lnTo>
                <a:cubicBezTo>
                  <a:pt x="413419" y="99139"/>
                  <a:pt x="507074" y="103079"/>
                  <a:pt x="548640" y="82296"/>
                </a:cubicBezTo>
                <a:cubicBezTo>
                  <a:pt x="558470" y="77381"/>
                  <a:pt x="566928" y="70104"/>
                  <a:pt x="576072" y="64008"/>
                </a:cubicBezTo>
                <a:cubicBezTo>
                  <a:pt x="592756" y="38982"/>
                  <a:pt x="592916" y="31122"/>
                  <a:pt x="621792" y="18288"/>
                </a:cubicBezTo>
                <a:cubicBezTo>
                  <a:pt x="639408" y="10459"/>
                  <a:pt x="676656" y="0"/>
                  <a:pt x="676656" y="0"/>
                </a:cubicBezTo>
                <a:cubicBezTo>
                  <a:pt x="689323" y="2533"/>
                  <a:pt x="733992" y="9501"/>
                  <a:pt x="749808" y="18288"/>
                </a:cubicBezTo>
                <a:cubicBezTo>
                  <a:pt x="769021" y="28962"/>
                  <a:pt x="804672" y="54864"/>
                  <a:pt x="804672" y="54864"/>
                </a:cubicBezTo>
                <a:lnTo>
                  <a:pt x="859536" y="137160"/>
                </a:lnTo>
                <a:cubicBezTo>
                  <a:pt x="911947" y="215776"/>
                  <a:pt x="849110" y="116308"/>
                  <a:pt x="886968" y="192024"/>
                </a:cubicBezTo>
                <a:cubicBezTo>
                  <a:pt x="888331" y="194750"/>
                  <a:pt x="886968" y="185928"/>
                  <a:pt x="886968" y="182880"/>
                </a:cubicBezTo>
              </a:path>
            </a:pathLst>
          </a:custGeom>
          <a:noFill/>
          <a:ln w="63500">
            <a:solidFill>
              <a:schemeClr val="tx1"/>
            </a:solidFill>
            <a:prstDash val="sysDot"/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Freeform 7">
            <a:extLst>
              <a:ext uri="{FF2B5EF4-FFF2-40B4-BE49-F238E27FC236}">
                <a16:creationId xmlns:a16="http://schemas.microsoft.com/office/drawing/2014/main" id="{CE3049E4-F9FC-C340-89DB-68E37A9D1051}"/>
              </a:ext>
            </a:extLst>
          </p:cNvPr>
          <p:cNvSpPr/>
          <p:nvPr/>
        </p:nvSpPr>
        <p:spPr>
          <a:xfrm>
            <a:off x="7637440" y="4559499"/>
            <a:ext cx="1938528" cy="859536"/>
          </a:xfrm>
          <a:custGeom>
            <a:avLst/>
            <a:gdLst>
              <a:gd name="connsiteX0" fmla="*/ 1837944 w 1938528"/>
              <a:gd name="connsiteY0" fmla="*/ 0 h 859536"/>
              <a:gd name="connsiteX1" fmla="*/ 1883664 w 1938528"/>
              <a:gd name="connsiteY1" fmla="*/ 73152 h 859536"/>
              <a:gd name="connsiteX2" fmla="*/ 1901952 w 1938528"/>
              <a:gd name="connsiteY2" fmla="*/ 192024 h 859536"/>
              <a:gd name="connsiteX3" fmla="*/ 1920240 w 1938528"/>
              <a:gd name="connsiteY3" fmla="*/ 219456 h 859536"/>
              <a:gd name="connsiteX4" fmla="*/ 1938528 w 1938528"/>
              <a:gd name="connsiteY4" fmla="*/ 274320 h 859536"/>
              <a:gd name="connsiteX5" fmla="*/ 1929384 w 1938528"/>
              <a:gd name="connsiteY5" fmla="*/ 374904 h 859536"/>
              <a:gd name="connsiteX6" fmla="*/ 1920240 w 1938528"/>
              <a:gd name="connsiteY6" fmla="*/ 402336 h 859536"/>
              <a:gd name="connsiteX7" fmla="*/ 1810512 w 1938528"/>
              <a:gd name="connsiteY7" fmla="*/ 457200 h 859536"/>
              <a:gd name="connsiteX8" fmla="*/ 1783080 w 1938528"/>
              <a:gd name="connsiteY8" fmla="*/ 466344 h 859536"/>
              <a:gd name="connsiteX9" fmla="*/ 1755648 w 1938528"/>
              <a:gd name="connsiteY9" fmla="*/ 475488 h 859536"/>
              <a:gd name="connsiteX10" fmla="*/ 1664208 w 1938528"/>
              <a:gd name="connsiteY10" fmla="*/ 493776 h 859536"/>
              <a:gd name="connsiteX11" fmla="*/ 1636776 w 1938528"/>
              <a:gd name="connsiteY11" fmla="*/ 502920 h 859536"/>
              <a:gd name="connsiteX12" fmla="*/ 1581912 w 1938528"/>
              <a:gd name="connsiteY12" fmla="*/ 548640 h 859536"/>
              <a:gd name="connsiteX13" fmla="*/ 1545336 w 1938528"/>
              <a:gd name="connsiteY13" fmla="*/ 603504 h 859536"/>
              <a:gd name="connsiteX14" fmla="*/ 1508760 w 1938528"/>
              <a:gd name="connsiteY14" fmla="*/ 658368 h 859536"/>
              <a:gd name="connsiteX15" fmla="*/ 1463040 w 1938528"/>
              <a:gd name="connsiteY15" fmla="*/ 713232 h 859536"/>
              <a:gd name="connsiteX16" fmla="*/ 1408176 w 1938528"/>
              <a:gd name="connsiteY16" fmla="*/ 731520 h 859536"/>
              <a:gd name="connsiteX17" fmla="*/ 1353312 w 1938528"/>
              <a:gd name="connsiteY17" fmla="*/ 749808 h 859536"/>
              <a:gd name="connsiteX18" fmla="*/ 1325880 w 1938528"/>
              <a:gd name="connsiteY18" fmla="*/ 758952 h 859536"/>
              <a:gd name="connsiteX19" fmla="*/ 1024128 w 1938528"/>
              <a:gd name="connsiteY19" fmla="*/ 768096 h 859536"/>
              <a:gd name="connsiteX20" fmla="*/ 969264 w 1938528"/>
              <a:gd name="connsiteY20" fmla="*/ 786384 h 859536"/>
              <a:gd name="connsiteX21" fmla="*/ 886968 w 1938528"/>
              <a:gd name="connsiteY21" fmla="*/ 850392 h 859536"/>
              <a:gd name="connsiteX22" fmla="*/ 850392 w 1938528"/>
              <a:gd name="connsiteY22" fmla="*/ 859536 h 859536"/>
              <a:gd name="connsiteX23" fmla="*/ 667512 w 1938528"/>
              <a:gd name="connsiteY23" fmla="*/ 850392 h 859536"/>
              <a:gd name="connsiteX24" fmla="*/ 640080 w 1938528"/>
              <a:gd name="connsiteY24" fmla="*/ 832104 h 859536"/>
              <a:gd name="connsiteX25" fmla="*/ 612648 w 1938528"/>
              <a:gd name="connsiteY25" fmla="*/ 822960 h 859536"/>
              <a:gd name="connsiteX26" fmla="*/ 594360 w 1938528"/>
              <a:gd name="connsiteY26" fmla="*/ 795528 h 859536"/>
              <a:gd name="connsiteX27" fmla="*/ 484632 w 1938528"/>
              <a:gd name="connsiteY27" fmla="*/ 740664 h 859536"/>
              <a:gd name="connsiteX28" fmla="*/ 429768 w 1938528"/>
              <a:gd name="connsiteY28" fmla="*/ 722376 h 859536"/>
              <a:gd name="connsiteX29" fmla="*/ 402336 w 1938528"/>
              <a:gd name="connsiteY29" fmla="*/ 713232 h 859536"/>
              <a:gd name="connsiteX30" fmla="*/ 237744 w 1938528"/>
              <a:gd name="connsiteY30" fmla="*/ 731520 h 859536"/>
              <a:gd name="connsiteX31" fmla="*/ 182880 w 1938528"/>
              <a:gd name="connsiteY31" fmla="*/ 749808 h 859536"/>
              <a:gd name="connsiteX32" fmla="*/ 91440 w 1938528"/>
              <a:gd name="connsiteY32" fmla="*/ 731520 h 859536"/>
              <a:gd name="connsiteX33" fmla="*/ 27432 w 1938528"/>
              <a:gd name="connsiteY33" fmla="*/ 649224 h 859536"/>
              <a:gd name="connsiteX34" fmla="*/ 0 w 1938528"/>
              <a:gd name="connsiteY34" fmla="*/ 594360 h 859536"/>
              <a:gd name="connsiteX35" fmla="*/ 9144 w 1938528"/>
              <a:gd name="connsiteY35" fmla="*/ 466344 h 859536"/>
              <a:gd name="connsiteX36" fmla="*/ 18288 w 1938528"/>
              <a:gd name="connsiteY36" fmla="*/ 438912 h 859536"/>
              <a:gd name="connsiteX37" fmla="*/ 27432 w 1938528"/>
              <a:gd name="connsiteY37" fmla="*/ 402336 h 859536"/>
              <a:gd name="connsiteX38" fmla="*/ 36576 w 1938528"/>
              <a:gd name="connsiteY38" fmla="*/ 329184 h 859536"/>
              <a:gd name="connsiteX39" fmla="*/ 45720 w 1938528"/>
              <a:gd name="connsiteY39" fmla="*/ 155448 h 859536"/>
              <a:gd name="connsiteX40" fmla="*/ 54864 w 1938528"/>
              <a:gd name="connsiteY40" fmla="*/ 128016 h 859536"/>
              <a:gd name="connsiteX41" fmla="*/ 82296 w 1938528"/>
              <a:gd name="connsiteY41" fmla="*/ 109728 h 859536"/>
              <a:gd name="connsiteX42" fmla="*/ 155448 w 1938528"/>
              <a:gd name="connsiteY42" fmla="*/ 45720 h 859536"/>
              <a:gd name="connsiteX43" fmla="*/ 210312 w 1938528"/>
              <a:gd name="connsiteY43" fmla="*/ 27432 h 859536"/>
              <a:gd name="connsiteX44" fmla="*/ 237744 w 1938528"/>
              <a:gd name="connsiteY44" fmla="*/ 18288 h 859536"/>
              <a:gd name="connsiteX45" fmla="*/ 402336 w 1938528"/>
              <a:gd name="connsiteY45" fmla="*/ 27432 h 859536"/>
              <a:gd name="connsiteX46" fmla="*/ 438912 w 1938528"/>
              <a:gd name="connsiteY46" fmla="*/ 36576 h 859536"/>
              <a:gd name="connsiteX47" fmla="*/ 493776 w 1938528"/>
              <a:gd name="connsiteY47" fmla="*/ 45720 h 859536"/>
              <a:gd name="connsiteX48" fmla="*/ 566928 w 1938528"/>
              <a:gd name="connsiteY48" fmla="*/ 64008 h 859536"/>
              <a:gd name="connsiteX49" fmla="*/ 749808 w 1938528"/>
              <a:gd name="connsiteY49" fmla="*/ 64008 h 8595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</a:cxnLst>
            <a:rect l="l" t="t" r="r" b="b"/>
            <a:pathLst>
              <a:path w="1938528" h="859536">
                <a:moveTo>
                  <a:pt x="1837944" y="0"/>
                </a:moveTo>
                <a:cubicBezTo>
                  <a:pt x="1859867" y="27403"/>
                  <a:pt x="1878559" y="39968"/>
                  <a:pt x="1883664" y="73152"/>
                </a:cubicBezTo>
                <a:cubicBezTo>
                  <a:pt x="1888326" y="103456"/>
                  <a:pt x="1884833" y="157787"/>
                  <a:pt x="1901952" y="192024"/>
                </a:cubicBezTo>
                <a:cubicBezTo>
                  <a:pt x="1906867" y="201854"/>
                  <a:pt x="1915777" y="209413"/>
                  <a:pt x="1920240" y="219456"/>
                </a:cubicBezTo>
                <a:cubicBezTo>
                  <a:pt x="1928069" y="237072"/>
                  <a:pt x="1938528" y="274320"/>
                  <a:pt x="1938528" y="274320"/>
                </a:cubicBezTo>
                <a:cubicBezTo>
                  <a:pt x="1935480" y="307848"/>
                  <a:pt x="1934145" y="341576"/>
                  <a:pt x="1929384" y="374904"/>
                </a:cubicBezTo>
                <a:cubicBezTo>
                  <a:pt x="1928021" y="384446"/>
                  <a:pt x="1927056" y="395520"/>
                  <a:pt x="1920240" y="402336"/>
                </a:cubicBezTo>
                <a:cubicBezTo>
                  <a:pt x="1884788" y="437788"/>
                  <a:pt x="1855134" y="442326"/>
                  <a:pt x="1810512" y="457200"/>
                </a:cubicBezTo>
                <a:lnTo>
                  <a:pt x="1783080" y="466344"/>
                </a:lnTo>
                <a:cubicBezTo>
                  <a:pt x="1773936" y="469392"/>
                  <a:pt x="1765099" y="473598"/>
                  <a:pt x="1755648" y="475488"/>
                </a:cubicBezTo>
                <a:cubicBezTo>
                  <a:pt x="1725168" y="481584"/>
                  <a:pt x="1693697" y="483946"/>
                  <a:pt x="1664208" y="493776"/>
                </a:cubicBezTo>
                <a:cubicBezTo>
                  <a:pt x="1655064" y="496824"/>
                  <a:pt x="1645397" y="498609"/>
                  <a:pt x="1636776" y="502920"/>
                </a:cubicBezTo>
                <a:cubicBezTo>
                  <a:pt x="1617564" y="512526"/>
                  <a:pt x="1594781" y="532094"/>
                  <a:pt x="1581912" y="548640"/>
                </a:cubicBezTo>
                <a:cubicBezTo>
                  <a:pt x="1568418" y="565990"/>
                  <a:pt x="1557528" y="585216"/>
                  <a:pt x="1545336" y="603504"/>
                </a:cubicBezTo>
                <a:lnTo>
                  <a:pt x="1508760" y="658368"/>
                </a:lnTo>
                <a:cubicBezTo>
                  <a:pt x="1497377" y="675442"/>
                  <a:pt x="1481677" y="702878"/>
                  <a:pt x="1463040" y="713232"/>
                </a:cubicBezTo>
                <a:cubicBezTo>
                  <a:pt x="1446189" y="722594"/>
                  <a:pt x="1426464" y="725424"/>
                  <a:pt x="1408176" y="731520"/>
                </a:cubicBezTo>
                <a:lnTo>
                  <a:pt x="1353312" y="749808"/>
                </a:lnTo>
                <a:cubicBezTo>
                  <a:pt x="1344168" y="752856"/>
                  <a:pt x="1335514" y="758660"/>
                  <a:pt x="1325880" y="758952"/>
                </a:cubicBezTo>
                <a:lnTo>
                  <a:pt x="1024128" y="768096"/>
                </a:lnTo>
                <a:cubicBezTo>
                  <a:pt x="1005840" y="774192"/>
                  <a:pt x="982895" y="772753"/>
                  <a:pt x="969264" y="786384"/>
                </a:cubicBezTo>
                <a:cubicBezTo>
                  <a:pt x="947740" y="807908"/>
                  <a:pt x="916134" y="843100"/>
                  <a:pt x="886968" y="850392"/>
                </a:cubicBezTo>
                <a:lnTo>
                  <a:pt x="850392" y="859536"/>
                </a:lnTo>
                <a:cubicBezTo>
                  <a:pt x="789432" y="856488"/>
                  <a:pt x="728035" y="858286"/>
                  <a:pt x="667512" y="850392"/>
                </a:cubicBezTo>
                <a:cubicBezTo>
                  <a:pt x="656615" y="848971"/>
                  <a:pt x="649910" y="837019"/>
                  <a:pt x="640080" y="832104"/>
                </a:cubicBezTo>
                <a:cubicBezTo>
                  <a:pt x="631459" y="827793"/>
                  <a:pt x="621792" y="826008"/>
                  <a:pt x="612648" y="822960"/>
                </a:cubicBezTo>
                <a:cubicBezTo>
                  <a:pt x="606552" y="813816"/>
                  <a:pt x="602631" y="802765"/>
                  <a:pt x="594360" y="795528"/>
                </a:cubicBezTo>
                <a:cubicBezTo>
                  <a:pt x="550727" y="757349"/>
                  <a:pt x="536430" y="757930"/>
                  <a:pt x="484632" y="740664"/>
                </a:cubicBezTo>
                <a:lnTo>
                  <a:pt x="429768" y="722376"/>
                </a:lnTo>
                <a:lnTo>
                  <a:pt x="402336" y="713232"/>
                </a:lnTo>
                <a:cubicBezTo>
                  <a:pt x="364271" y="716404"/>
                  <a:pt x="283278" y="720137"/>
                  <a:pt x="237744" y="731520"/>
                </a:cubicBezTo>
                <a:cubicBezTo>
                  <a:pt x="219042" y="736195"/>
                  <a:pt x="182880" y="749808"/>
                  <a:pt x="182880" y="749808"/>
                </a:cubicBezTo>
                <a:cubicBezTo>
                  <a:pt x="177459" y="749034"/>
                  <a:pt x="108850" y="743127"/>
                  <a:pt x="91440" y="731520"/>
                </a:cubicBezTo>
                <a:cubicBezTo>
                  <a:pt x="65656" y="714330"/>
                  <a:pt x="41965" y="671023"/>
                  <a:pt x="27432" y="649224"/>
                </a:cubicBezTo>
                <a:cubicBezTo>
                  <a:pt x="3797" y="613772"/>
                  <a:pt x="12619" y="632218"/>
                  <a:pt x="0" y="594360"/>
                </a:cubicBezTo>
                <a:cubicBezTo>
                  <a:pt x="3048" y="551688"/>
                  <a:pt x="4145" y="508832"/>
                  <a:pt x="9144" y="466344"/>
                </a:cubicBezTo>
                <a:cubicBezTo>
                  <a:pt x="10270" y="456771"/>
                  <a:pt x="15640" y="448180"/>
                  <a:pt x="18288" y="438912"/>
                </a:cubicBezTo>
                <a:cubicBezTo>
                  <a:pt x="21740" y="426828"/>
                  <a:pt x="25366" y="414732"/>
                  <a:pt x="27432" y="402336"/>
                </a:cubicBezTo>
                <a:cubicBezTo>
                  <a:pt x="31472" y="378097"/>
                  <a:pt x="33528" y="353568"/>
                  <a:pt x="36576" y="329184"/>
                </a:cubicBezTo>
                <a:cubicBezTo>
                  <a:pt x="39624" y="271272"/>
                  <a:pt x="40470" y="213202"/>
                  <a:pt x="45720" y="155448"/>
                </a:cubicBezTo>
                <a:cubicBezTo>
                  <a:pt x="46593" y="145849"/>
                  <a:pt x="48843" y="135542"/>
                  <a:pt x="54864" y="128016"/>
                </a:cubicBezTo>
                <a:cubicBezTo>
                  <a:pt x="61729" y="119434"/>
                  <a:pt x="73152" y="115824"/>
                  <a:pt x="82296" y="109728"/>
                </a:cubicBezTo>
                <a:cubicBezTo>
                  <a:pt x="103632" y="77724"/>
                  <a:pt x="109728" y="60960"/>
                  <a:pt x="155448" y="45720"/>
                </a:cubicBezTo>
                <a:lnTo>
                  <a:pt x="210312" y="27432"/>
                </a:lnTo>
                <a:lnTo>
                  <a:pt x="237744" y="18288"/>
                </a:lnTo>
                <a:cubicBezTo>
                  <a:pt x="292608" y="21336"/>
                  <a:pt x="347613" y="22457"/>
                  <a:pt x="402336" y="27432"/>
                </a:cubicBezTo>
                <a:cubicBezTo>
                  <a:pt x="414852" y="28570"/>
                  <a:pt x="426589" y="34111"/>
                  <a:pt x="438912" y="36576"/>
                </a:cubicBezTo>
                <a:cubicBezTo>
                  <a:pt x="457092" y="40212"/>
                  <a:pt x="475647" y="41835"/>
                  <a:pt x="493776" y="45720"/>
                </a:cubicBezTo>
                <a:cubicBezTo>
                  <a:pt x="518353" y="50986"/>
                  <a:pt x="541794" y="64008"/>
                  <a:pt x="566928" y="64008"/>
                </a:cubicBezTo>
                <a:lnTo>
                  <a:pt x="749808" y="64008"/>
                </a:lnTo>
              </a:path>
            </a:pathLst>
          </a:custGeom>
          <a:noFill/>
          <a:ln w="63500">
            <a:solidFill>
              <a:schemeClr val="tx1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reeform 10">
            <a:extLst>
              <a:ext uri="{FF2B5EF4-FFF2-40B4-BE49-F238E27FC236}">
                <a16:creationId xmlns:a16="http://schemas.microsoft.com/office/drawing/2014/main" id="{69CDB12C-1E1F-6446-8CA7-9FD6F9D1B740}"/>
              </a:ext>
            </a:extLst>
          </p:cNvPr>
          <p:cNvSpPr/>
          <p:nvPr/>
        </p:nvSpPr>
        <p:spPr>
          <a:xfrm>
            <a:off x="8579272" y="4029147"/>
            <a:ext cx="457200" cy="265176"/>
          </a:xfrm>
          <a:custGeom>
            <a:avLst/>
            <a:gdLst>
              <a:gd name="connsiteX0" fmla="*/ 0 w 457200"/>
              <a:gd name="connsiteY0" fmla="*/ 192024 h 265176"/>
              <a:gd name="connsiteX1" fmla="*/ 9144 w 457200"/>
              <a:gd name="connsiteY1" fmla="*/ 237744 h 265176"/>
              <a:gd name="connsiteX2" fmla="*/ 64008 w 457200"/>
              <a:gd name="connsiteY2" fmla="*/ 265176 h 265176"/>
              <a:gd name="connsiteX3" fmla="*/ 256032 w 457200"/>
              <a:gd name="connsiteY3" fmla="*/ 265176 h 265176"/>
              <a:gd name="connsiteX4" fmla="*/ 393192 w 457200"/>
              <a:gd name="connsiteY4" fmla="*/ 246888 h 265176"/>
              <a:gd name="connsiteX5" fmla="*/ 420624 w 457200"/>
              <a:gd name="connsiteY5" fmla="*/ 237744 h 265176"/>
              <a:gd name="connsiteX6" fmla="*/ 420624 w 457200"/>
              <a:gd name="connsiteY6" fmla="*/ 27432 h 265176"/>
              <a:gd name="connsiteX7" fmla="*/ 448056 w 457200"/>
              <a:gd name="connsiteY7" fmla="*/ 9144 h 265176"/>
              <a:gd name="connsiteX8" fmla="*/ 457200 w 457200"/>
              <a:gd name="connsiteY8" fmla="*/ 0 h 2651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457200" h="265176">
                <a:moveTo>
                  <a:pt x="0" y="192024"/>
                </a:moveTo>
                <a:cubicBezTo>
                  <a:pt x="3048" y="207264"/>
                  <a:pt x="1433" y="224250"/>
                  <a:pt x="9144" y="237744"/>
                </a:cubicBezTo>
                <a:cubicBezTo>
                  <a:pt x="17486" y="252342"/>
                  <a:pt x="49927" y="260482"/>
                  <a:pt x="64008" y="265176"/>
                </a:cubicBezTo>
                <a:cubicBezTo>
                  <a:pt x="208029" y="244602"/>
                  <a:pt x="31761" y="265176"/>
                  <a:pt x="256032" y="265176"/>
                </a:cubicBezTo>
                <a:cubicBezTo>
                  <a:pt x="290312" y="265176"/>
                  <a:pt x="354282" y="256615"/>
                  <a:pt x="393192" y="246888"/>
                </a:cubicBezTo>
                <a:cubicBezTo>
                  <a:pt x="402543" y="244550"/>
                  <a:pt x="411480" y="240792"/>
                  <a:pt x="420624" y="237744"/>
                </a:cubicBezTo>
                <a:cubicBezTo>
                  <a:pt x="418535" y="206405"/>
                  <a:pt x="401136" y="76151"/>
                  <a:pt x="420624" y="27432"/>
                </a:cubicBezTo>
                <a:cubicBezTo>
                  <a:pt x="424705" y="17228"/>
                  <a:pt x="439264" y="15738"/>
                  <a:pt x="448056" y="9144"/>
                </a:cubicBezTo>
                <a:cubicBezTo>
                  <a:pt x="451504" y="6558"/>
                  <a:pt x="454152" y="3048"/>
                  <a:pt x="457200" y="0"/>
                </a:cubicBezTo>
              </a:path>
            </a:pathLst>
          </a:custGeom>
          <a:noFill/>
          <a:ln w="857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 11">
            <a:extLst>
              <a:ext uri="{FF2B5EF4-FFF2-40B4-BE49-F238E27FC236}">
                <a16:creationId xmlns:a16="http://schemas.microsoft.com/office/drawing/2014/main" id="{B81D9F37-42D1-B040-9067-3AD98B7A0704}"/>
              </a:ext>
            </a:extLst>
          </p:cNvPr>
          <p:cNvSpPr/>
          <p:nvPr/>
        </p:nvSpPr>
        <p:spPr>
          <a:xfrm>
            <a:off x="8194201" y="4623507"/>
            <a:ext cx="1235463" cy="521208"/>
          </a:xfrm>
          <a:custGeom>
            <a:avLst/>
            <a:gdLst>
              <a:gd name="connsiteX0" fmla="*/ 46743 w 1235463"/>
              <a:gd name="connsiteY0" fmla="*/ 429768 h 521208"/>
              <a:gd name="connsiteX1" fmla="*/ 1023 w 1235463"/>
              <a:gd name="connsiteY1" fmla="*/ 457200 h 521208"/>
              <a:gd name="connsiteX2" fmla="*/ 19311 w 1235463"/>
              <a:gd name="connsiteY2" fmla="*/ 484632 h 521208"/>
              <a:gd name="connsiteX3" fmla="*/ 74175 w 1235463"/>
              <a:gd name="connsiteY3" fmla="*/ 502920 h 521208"/>
              <a:gd name="connsiteX4" fmla="*/ 101607 w 1235463"/>
              <a:gd name="connsiteY4" fmla="*/ 521208 h 521208"/>
              <a:gd name="connsiteX5" fmla="*/ 147327 w 1235463"/>
              <a:gd name="connsiteY5" fmla="*/ 512064 h 521208"/>
              <a:gd name="connsiteX6" fmla="*/ 174759 w 1235463"/>
              <a:gd name="connsiteY6" fmla="*/ 502920 h 521208"/>
              <a:gd name="connsiteX7" fmla="*/ 238767 w 1235463"/>
              <a:gd name="connsiteY7" fmla="*/ 521208 h 521208"/>
              <a:gd name="connsiteX8" fmla="*/ 266199 w 1235463"/>
              <a:gd name="connsiteY8" fmla="*/ 512064 h 521208"/>
              <a:gd name="connsiteX9" fmla="*/ 284487 w 1235463"/>
              <a:gd name="connsiteY9" fmla="*/ 457200 h 521208"/>
              <a:gd name="connsiteX10" fmla="*/ 293631 w 1235463"/>
              <a:gd name="connsiteY10" fmla="*/ 429768 h 521208"/>
              <a:gd name="connsiteX11" fmla="*/ 321063 w 1235463"/>
              <a:gd name="connsiteY11" fmla="*/ 411480 h 521208"/>
              <a:gd name="connsiteX12" fmla="*/ 375927 w 1235463"/>
              <a:gd name="connsiteY12" fmla="*/ 475488 h 521208"/>
              <a:gd name="connsiteX13" fmla="*/ 385071 w 1235463"/>
              <a:gd name="connsiteY13" fmla="*/ 502920 h 521208"/>
              <a:gd name="connsiteX14" fmla="*/ 430791 w 1235463"/>
              <a:gd name="connsiteY14" fmla="*/ 493776 h 521208"/>
              <a:gd name="connsiteX15" fmla="*/ 467367 w 1235463"/>
              <a:gd name="connsiteY15" fmla="*/ 411480 h 521208"/>
              <a:gd name="connsiteX16" fmla="*/ 522231 w 1235463"/>
              <a:gd name="connsiteY16" fmla="*/ 374904 h 521208"/>
              <a:gd name="connsiteX17" fmla="*/ 540519 w 1235463"/>
              <a:gd name="connsiteY17" fmla="*/ 429768 h 521208"/>
              <a:gd name="connsiteX18" fmla="*/ 549663 w 1235463"/>
              <a:gd name="connsiteY18" fmla="*/ 466344 h 521208"/>
              <a:gd name="connsiteX19" fmla="*/ 567951 w 1235463"/>
              <a:gd name="connsiteY19" fmla="*/ 493776 h 521208"/>
              <a:gd name="connsiteX20" fmla="*/ 677679 w 1235463"/>
              <a:gd name="connsiteY20" fmla="*/ 484632 h 521208"/>
              <a:gd name="connsiteX21" fmla="*/ 705111 w 1235463"/>
              <a:gd name="connsiteY21" fmla="*/ 457200 h 521208"/>
              <a:gd name="connsiteX22" fmla="*/ 695967 w 1235463"/>
              <a:gd name="connsiteY22" fmla="*/ 374904 h 521208"/>
              <a:gd name="connsiteX23" fmla="*/ 677679 w 1235463"/>
              <a:gd name="connsiteY23" fmla="*/ 320040 h 521208"/>
              <a:gd name="connsiteX24" fmla="*/ 686823 w 1235463"/>
              <a:gd name="connsiteY24" fmla="*/ 246888 h 521208"/>
              <a:gd name="connsiteX25" fmla="*/ 741687 w 1235463"/>
              <a:gd name="connsiteY25" fmla="*/ 228600 h 521208"/>
              <a:gd name="connsiteX26" fmla="*/ 769119 w 1235463"/>
              <a:gd name="connsiteY26" fmla="*/ 210312 h 521208"/>
              <a:gd name="connsiteX27" fmla="*/ 787407 w 1235463"/>
              <a:gd name="connsiteY27" fmla="*/ 182880 h 521208"/>
              <a:gd name="connsiteX28" fmla="*/ 759975 w 1235463"/>
              <a:gd name="connsiteY28" fmla="*/ 128016 h 521208"/>
              <a:gd name="connsiteX29" fmla="*/ 778263 w 1235463"/>
              <a:gd name="connsiteY29" fmla="*/ 100584 h 521208"/>
              <a:gd name="connsiteX30" fmla="*/ 833127 w 1235463"/>
              <a:gd name="connsiteY30" fmla="*/ 82296 h 521208"/>
              <a:gd name="connsiteX31" fmla="*/ 860559 w 1235463"/>
              <a:gd name="connsiteY31" fmla="*/ 91440 h 521208"/>
              <a:gd name="connsiteX32" fmla="*/ 869703 w 1235463"/>
              <a:gd name="connsiteY32" fmla="*/ 118872 h 521208"/>
              <a:gd name="connsiteX33" fmla="*/ 887991 w 1235463"/>
              <a:gd name="connsiteY33" fmla="*/ 192024 h 521208"/>
              <a:gd name="connsiteX34" fmla="*/ 906279 w 1235463"/>
              <a:gd name="connsiteY34" fmla="*/ 219456 h 521208"/>
              <a:gd name="connsiteX35" fmla="*/ 933711 w 1235463"/>
              <a:gd name="connsiteY35" fmla="*/ 228600 h 521208"/>
              <a:gd name="connsiteX36" fmla="*/ 961143 w 1235463"/>
              <a:gd name="connsiteY36" fmla="*/ 246888 h 521208"/>
              <a:gd name="connsiteX37" fmla="*/ 1016007 w 1235463"/>
              <a:gd name="connsiteY37" fmla="*/ 228600 h 521208"/>
              <a:gd name="connsiteX38" fmla="*/ 1043439 w 1235463"/>
              <a:gd name="connsiteY38" fmla="*/ 219456 h 521208"/>
              <a:gd name="connsiteX39" fmla="*/ 1052583 w 1235463"/>
              <a:gd name="connsiteY39" fmla="*/ 192024 h 521208"/>
              <a:gd name="connsiteX40" fmla="*/ 1107447 w 1235463"/>
              <a:gd name="connsiteY40" fmla="*/ 146304 h 521208"/>
              <a:gd name="connsiteX41" fmla="*/ 1171455 w 1235463"/>
              <a:gd name="connsiteY41" fmla="*/ 128016 h 521208"/>
              <a:gd name="connsiteX42" fmla="*/ 1198887 w 1235463"/>
              <a:gd name="connsiteY42" fmla="*/ 36576 h 521208"/>
              <a:gd name="connsiteX43" fmla="*/ 1208031 w 1235463"/>
              <a:gd name="connsiteY43" fmla="*/ 9144 h 521208"/>
              <a:gd name="connsiteX44" fmla="*/ 1235463 w 1235463"/>
              <a:gd name="connsiteY44" fmla="*/ 0 h 5212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</a:cxnLst>
            <a:rect l="l" t="t" r="r" b="b"/>
            <a:pathLst>
              <a:path w="1235463" h="521208">
                <a:moveTo>
                  <a:pt x="46743" y="429768"/>
                </a:moveTo>
                <a:cubicBezTo>
                  <a:pt x="31503" y="438912"/>
                  <a:pt x="8971" y="441304"/>
                  <a:pt x="1023" y="457200"/>
                </a:cubicBezTo>
                <a:cubicBezTo>
                  <a:pt x="-3892" y="467030"/>
                  <a:pt x="9992" y="478807"/>
                  <a:pt x="19311" y="484632"/>
                </a:cubicBezTo>
                <a:cubicBezTo>
                  <a:pt x="35658" y="494849"/>
                  <a:pt x="58135" y="492227"/>
                  <a:pt x="74175" y="502920"/>
                </a:cubicBezTo>
                <a:lnTo>
                  <a:pt x="101607" y="521208"/>
                </a:lnTo>
                <a:cubicBezTo>
                  <a:pt x="116847" y="518160"/>
                  <a:pt x="132249" y="515833"/>
                  <a:pt x="147327" y="512064"/>
                </a:cubicBezTo>
                <a:cubicBezTo>
                  <a:pt x="156678" y="509726"/>
                  <a:pt x="165120" y="502920"/>
                  <a:pt x="174759" y="502920"/>
                </a:cubicBezTo>
                <a:cubicBezTo>
                  <a:pt x="186241" y="502920"/>
                  <a:pt x="225831" y="516896"/>
                  <a:pt x="238767" y="521208"/>
                </a:cubicBezTo>
                <a:cubicBezTo>
                  <a:pt x="247911" y="518160"/>
                  <a:pt x="260597" y="519907"/>
                  <a:pt x="266199" y="512064"/>
                </a:cubicBezTo>
                <a:cubicBezTo>
                  <a:pt x="277404" y="496377"/>
                  <a:pt x="278391" y="475488"/>
                  <a:pt x="284487" y="457200"/>
                </a:cubicBezTo>
                <a:cubicBezTo>
                  <a:pt x="287535" y="448056"/>
                  <a:pt x="285611" y="435115"/>
                  <a:pt x="293631" y="429768"/>
                </a:cubicBezTo>
                <a:lnTo>
                  <a:pt x="321063" y="411480"/>
                </a:lnTo>
                <a:cubicBezTo>
                  <a:pt x="376341" y="425299"/>
                  <a:pt x="353665" y="408702"/>
                  <a:pt x="375927" y="475488"/>
                </a:cubicBezTo>
                <a:lnTo>
                  <a:pt x="385071" y="502920"/>
                </a:lnTo>
                <a:cubicBezTo>
                  <a:pt x="400311" y="499872"/>
                  <a:pt x="417297" y="501487"/>
                  <a:pt x="430791" y="493776"/>
                </a:cubicBezTo>
                <a:cubicBezTo>
                  <a:pt x="454879" y="480011"/>
                  <a:pt x="454187" y="424660"/>
                  <a:pt x="467367" y="411480"/>
                </a:cubicBezTo>
                <a:cubicBezTo>
                  <a:pt x="501615" y="377232"/>
                  <a:pt x="482531" y="388137"/>
                  <a:pt x="522231" y="374904"/>
                </a:cubicBezTo>
                <a:cubicBezTo>
                  <a:pt x="528327" y="393192"/>
                  <a:pt x="535844" y="411066"/>
                  <a:pt x="540519" y="429768"/>
                </a:cubicBezTo>
                <a:cubicBezTo>
                  <a:pt x="543567" y="441960"/>
                  <a:pt x="544713" y="454793"/>
                  <a:pt x="549663" y="466344"/>
                </a:cubicBezTo>
                <a:cubicBezTo>
                  <a:pt x="553992" y="476445"/>
                  <a:pt x="561855" y="484632"/>
                  <a:pt x="567951" y="493776"/>
                </a:cubicBezTo>
                <a:cubicBezTo>
                  <a:pt x="604527" y="490728"/>
                  <a:pt x="642215" y="494089"/>
                  <a:pt x="677679" y="484632"/>
                </a:cubicBezTo>
                <a:cubicBezTo>
                  <a:pt x="690174" y="481300"/>
                  <a:pt x="702985" y="469956"/>
                  <a:pt x="705111" y="457200"/>
                </a:cubicBezTo>
                <a:cubicBezTo>
                  <a:pt x="709649" y="429975"/>
                  <a:pt x="701380" y="401969"/>
                  <a:pt x="695967" y="374904"/>
                </a:cubicBezTo>
                <a:cubicBezTo>
                  <a:pt x="692186" y="356001"/>
                  <a:pt x="677679" y="320040"/>
                  <a:pt x="677679" y="320040"/>
                </a:cubicBezTo>
                <a:cubicBezTo>
                  <a:pt x="680727" y="295656"/>
                  <a:pt x="672731" y="267020"/>
                  <a:pt x="686823" y="246888"/>
                </a:cubicBezTo>
                <a:cubicBezTo>
                  <a:pt x="697878" y="231095"/>
                  <a:pt x="725647" y="239293"/>
                  <a:pt x="741687" y="228600"/>
                </a:cubicBezTo>
                <a:lnTo>
                  <a:pt x="769119" y="210312"/>
                </a:lnTo>
                <a:cubicBezTo>
                  <a:pt x="775215" y="201168"/>
                  <a:pt x="785600" y="193720"/>
                  <a:pt x="787407" y="182880"/>
                </a:cubicBezTo>
                <a:cubicBezTo>
                  <a:pt x="789931" y="167737"/>
                  <a:pt x="766344" y="137569"/>
                  <a:pt x="759975" y="128016"/>
                </a:cubicBezTo>
                <a:cubicBezTo>
                  <a:pt x="766071" y="118872"/>
                  <a:pt x="768944" y="106409"/>
                  <a:pt x="778263" y="100584"/>
                </a:cubicBezTo>
                <a:cubicBezTo>
                  <a:pt x="794610" y="90367"/>
                  <a:pt x="833127" y="82296"/>
                  <a:pt x="833127" y="82296"/>
                </a:cubicBezTo>
                <a:cubicBezTo>
                  <a:pt x="842271" y="85344"/>
                  <a:pt x="853743" y="84624"/>
                  <a:pt x="860559" y="91440"/>
                </a:cubicBezTo>
                <a:cubicBezTo>
                  <a:pt x="867375" y="98256"/>
                  <a:pt x="867167" y="109573"/>
                  <a:pt x="869703" y="118872"/>
                </a:cubicBezTo>
                <a:cubicBezTo>
                  <a:pt x="876316" y="143121"/>
                  <a:pt x="874049" y="171111"/>
                  <a:pt x="887991" y="192024"/>
                </a:cubicBezTo>
                <a:cubicBezTo>
                  <a:pt x="894087" y="201168"/>
                  <a:pt x="897697" y="212591"/>
                  <a:pt x="906279" y="219456"/>
                </a:cubicBezTo>
                <a:cubicBezTo>
                  <a:pt x="913805" y="225477"/>
                  <a:pt x="925090" y="224289"/>
                  <a:pt x="933711" y="228600"/>
                </a:cubicBezTo>
                <a:cubicBezTo>
                  <a:pt x="943541" y="233515"/>
                  <a:pt x="951999" y="240792"/>
                  <a:pt x="961143" y="246888"/>
                </a:cubicBezTo>
                <a:lnTo>
                  <a:pt x="1016007" y="228600"/>
                </a:lnTo>
                <a:lnTo>
                  <a:pt x="1043439" y="219456"/>
                </a:lnTo>
                <a:cubicBezTo>
                  <a:pt x="1046487" y="210312"/>
                  <a:pt x="1047236" y="200044"/>
                  <a:pt x="1052583" y="192024"/>
                </a:cubicBezTo>
                <a:cubicBezTo>
                  <a:pt x="1062694" y="176857"/>
                  <a:pt x="1090579" y="154738"/>
                  <a:pt x="1107447" y="146304"/>
                </a:cubicBezTo>
                <a:cubicBezTo>
                  <a:pt x="1120565" y="139745"/>
                  <a:pt x="1159736" y="130946"/>
                  <a:pt x="1171455" y="128016"/>
                </a:cubicBezTo>
                <a:cubicBezTo>
                  <a:pt x="1204815" y="77975"/>
                  <a:pt x="1182076" y="120633"/>
                  <a:pt x="1198887" y="36576"/>
                </a:cubicBezTo>
                <a:cubicBezTo>
                  <a:pt x="1200777" y="27125"/>
                  <a:pt x="1201215" y="15960"/>
                  <a:pt x="1208031" y="9144"/>
                </a:cubicBezTo>
                <a:cubicBezTo>
                  <a:pt x="1214847" y="2328"/>
                  <a:pt x="1235463" y="0"/>
                  <a:pt x="1235463" y="0"/>
                </a:cubicBezTo>
              </a:path>
            </a:pathLst>
          </a:custGeom>
          <a:noFill/>
          <a:ln w="825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B664F8F8-875D-A14F-BB55-4BAAA67C24B5}"/>
              </a:ext>
            </a:extLst>
          </p:cNvPr>
          <p:cNvSpPr txBox="1">
            <a:spLocks/>
          </p:cNvSpPr>
          <p:nvPr/>
        </p:nvSpPr>
        <p:spPr>
          <a:xfrm>
            <a:off x="2069562" y="1413012"/>
            <a:ext cx="368633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CB397458-CF4C-934D-8ED2-BFF2E1137CD9}"/>
              </a:ext>
            </a:extLst>
          </p:cNvPr>
          <p:cNvSpPr txBox="1">
            <a:spLocks/>
          </p:cNvSpPr>
          <p:nvPr/>
        </p:nvSpPr>
        <p:spPr>
          <a:xfrm>
            <a:off x="2781831" y="5292304"/>
            <a:ext cx="368633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posed VT circuit</a:t>
            </a:r>
          </a:p>
        </p:txBody>
      </p:sp>
      <p:sp>
        <p:nvSpPr>
          <p:cNvPr id="19" name="Freeform 18">
            <a:extLst>
              <a:ext uri="{FF2B5EF4-FFF2-40B4-BE49-F238E27FC236}">
                <a16:creationId xmlns:a16="http://schemas.microsoft.com/office/drawing/2014/main" id="{73D76DB6-89C1-0D44-AEE9-E95BF7231CDB}"/>
              </a:ext>
            </a:extLst>
          </p:cNvPr>
          <p:cNvSpPr/>
          <p:nvPr/>
        </p:nvSpPr>
        <p:spPr>
          <a:xfrm flipV="1">
            <a:off x="6934386" y="1734359"/>
            <a:ext cx="744907" cy="156768"/>
          </a:xfrm>
          <a:custGeom>
            <a:avLst/>
            <a:gdLst>
              <a:gd name="connsiteX0" fmla="*/ 0 w 1428750"/>
              <a:gd name="connsiteY0" fmla="*/ 57150 h 519362"/>
              <a:gd name="connsiteX1" fmla="*/ 71437 w 1428750"/>
              <a:gd name="connsiteY1" fmla="*/ 28575 h 519362"/>
              <a:gd name="connsiteX2" fmla="*/ 157162 w 1428750"/>
              <a:gd name="connsiteY2" fmla="*/ 0 h 519362"/>
              <a:gd name="connsiteX3" fmla="*/ 314325 w 1428750"/>
              <a:gd name="connsiteY3" fmla="*/ 28575 h 519362"/>
              <a:gd name="connsiteX4" fmla="*/ 400050 w 1428750"/>
              <a:gd name="connsiteY4" fmla="*/ 71438 h 519362"/>
              <a:gd name="connsiteX5" fmla="*/ 514350 w 1428750"/>
              <a:gd name="connsiteY5" fmla="*/ 85725 h 519362"/>
              <a:gd name="connsiteX6" fmla="*/ 614362 w 1428750"/>
              <a:gd name="connsiteY6" fmla="*/ 100013 h 519362"/>
              <a:gd name="connsiteX7" fmla="*/ 657225 w 1428750"/>
              <a:gd name="connsiteY7" fmla="*/ 128588 h 519362"/>
              <a:gd name="connsiteX8" fmla="*/ 685800 w 1428750"/>
              <a:gd name="connsiteY8" fmla="*/ 214313 h 519362"/>
              <a:gd name="connsiteX9" fmla="*/ 771525 w 1428750"/>
              <a:gd name="connsiteY9" fmla="*/ 157163 h 519362"/>
              <a:gd name="connsiteX10" fmla="*/ 914400 w 1428750"/>
              <a:gd name="connsiteY10" fmla="*/ 200025 h 519362"/>
              <a:gd name="connsiteX11" fmla="*/ 957262 w 1428750"/>
              <a:gd name="connsiteY11" fmla="*/ 214313 h 519362"/>
              <a:gd name="connsiteX12" fmla="*/ 1042987 w 1428750"/>
              <a:gd name="connsiteY12" fmla="*/ 228600 h 519362"/>
              <a:gd name="connsiteX13" fmla="*/ 1085850 w 1428750"/>
              <a:gd name="connsiteY13" fmla="*/ 242888 h 519362"/>
              <a:gd name="connsiteX14" fmla="*/ 1214437 w 1428750"/>
              <a:gd name="connsiteY14" fmla="*/ 342900 h 519362"/>
              <a:gd name="connsiteX15" fmla="*/ 1243012 w 1428750"/>
              <a:gd name="connsiteY15" fmla="*/ 385763 h 519362"/>
              <a:gd name="connsiteX16" fmla="*/ 1271587 w 1428750"/>
              <a:gd name="connsiteY16" fmla="*/ 471488 h 519362"/>
              <a:gd name="connsiteX17" fmla="*/ 1300162 w 1428750"/>
              <a:gd name="connsiteY17" fmla="*/ 514350 h 519362"/>
              <a:gd name="connsiteX18" fmla="*/ 1428750 w 1428750"/>
              <a:gd name="connsiteY18" fmla="*/ 514350 h 5193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428750" h="519362">
                <a:moveTo>
                  <a:pt x="0" y="57150"/>
                </a:moveTo>
                <a:cubicBezTo>
                  <a:pt x="23812" y="47625"/>
                  <a:pt x="47334" y="37340"/>
                  <a:pt x="71437" y="28575"/>
                </a:cubicBezTo>
                <a:cubicBezTo>
                  <a:pt x="99744" y="18281"/>
                  <a:pt x="157162" y="0"/>
                  <a:pt x="157162" y="0"/>
                </a:cubicBezTo>
                <a:cubicBezTo>
                  <a:pt x="196555" y="4924"/>
                  <a:pt x="270278" y="6552"/>
                  <a:pt x="314325" y="28575"/>
                </a:cubicBezTo>
                <a:cubicBezTo>
                  <a:pt x="366618" y="54721"/>
                  <a:pt x="343616" y="61177"/>
                  <a:pt x="400050" y="71438"/>
                </a:cubicBezTo>
                <a:cubicBezTo>
                  <a:pt x="437827" y="78307"/>
                  <a:pt x="476290" y="80650"/>
                  <a:pt x="514350" y="85725"/>
                </a:cubicBezTo>
                <a:lnTo>
                  <a:pt x="614362" y="100013"/>
                </a:lnTo>
                <a:cubicBezTo>
                  <a:pt x="628650" y="109538"/>
                  <a:pt x="648124" y="114027"/>
                  <a:pt x="657225" y="128588"/>
                </a:cubicBezTo>
                <a:cubicBezTo>
                  <a:pt x="673189" y="154130"/>
                  <a:pt x="685800" y="214313"/>
                  <a:pt x="685800" y="214313"/>
                </a:cubicBezTo>
                <a:cubicBezTo>
                  <a:pt x="714375" y="195263"/>
                  <a:pt x="738207" y="148834"/>
                  <a:pt x="771525" y="157163"/>
                </a:cubicBezTo>
                <a:cubicBezTo>
                  <a:pt x="857892" y="178754"/>
                  <a:pt x="810053" y="165242"/>
                  <a:pt x="914400" y="200025"/>
                </a:cubicBezTo>
                <a:cubicBezTo>
                  <a:pt x="928687" y="204788"/>
                  <a:pt x="942407" y="211837"/>
                  <a:pt x="957262" y="214313"/>
                </a:cubicBezTo>
                <a:lnTo>
                  <a:pt x="1042987" y="228600"/>
                </a:lnTo>
                <a:cubicBezTo>
                  <a:pt x="1057275" y="233363"/>
                  <a:pt x="1072685" y="235574"/>
                  <a:pt x="1085850" y="242888"/>
                </a:cubicBezTo>
                <a:cubicBezTo>
                  <a:pt x="1135288" y="270354"/>
                  <a:pt x="1178531" y="299812"/>
                  <a:pt x="1214437" y="342900"/>
                </a:cubicBezTo>
                <a:cubicBezTo>
                  <a:pt x="1225430" y="356092"/>
                  <a:pt x="1236038" y="370071"/>
                  <a:pt x="1243012" y="385763"/>
                </a:cubicBezTo>
                <a:cubicBezTo>
                  <a:pt x="1255245" y="413288"/>
                  <a:pt x="1254879" y="446426"/>
                  <a:pt x="1271587" y="471488"/>
                </a:cubicBezTo>
                <a:cubicBezTo>
                  <a:pt x="1281112" y="485775"/>
                  <a:pt x="1283596" y="509832"/>
                  <a:pt x="1300162" y="514350"/>
                </a:cubicBezTo>
                <a:cubicBezTo>
                  <a:pt x="1341514" y="525628"/>
                  <a:pt x="1385887" y="514350"/>
                  <a:pt x="1428750" y="514350"/>
                </a:cubicBezTo>
              </a:path>
            </a:pathLst>
          </a:custGeom>
          <a:noFill/>
          <a:ln w="857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37B2BF2-ACEB-D742-81F7-6543F1410382}"/>
              </a:ext>
            </a:extLst>
          </p:cNvPr>
          <p:cNvSpPr txBox="1"/>
          <p:nvPr/>
        </p:nvSpPr>
        <p:spPr>
          <a:xfrm>
            <a:off x="7679293" y="1554838"/>
            <a:ext cx="2396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nctional line of block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759DCDA-8837-C44E-8459-59AF525ACFE1}"/>
              </a:ext>
            </a:extLst>
          </p:cNvPr>
          <p:cNvCxnSpPr>
            <a:cxnSpLocks/>
          </p:cNvCxnSpPr>
          <p:nvPr/>
        </p:nvCxnSpPr>
        <p:spPr>
          <a:xfrm>
            <a:off x="2913476" y="4029147"/>
            <a:ext cx="490736" cy="530352"/>
          </a:xfrm>
          <a:prstGeom prst="straightConnector1">
            <a:avLst/>
          </a:prstGeom>
          <a:ln w="571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941356D-2DBE-904C-9256-F75D85D68B30}"/>
              </a:ext>
            </a:extLst>
          </p:cNvPr>
          <p:cNvSpPr txBox="1"/>
          <p:nvPr/>
        </p:nvSpPr>
        <p:spPr>
          <a:xfrm>
            <a:off x="3030774" y="3974468"/>
            <a:ext cx="6364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mm</a:t>
            </a:r>
          </a:p>
        </p:txBody>
      </p:sp>
    </p:spTree>
    <p:extLst>
      <p:ext uri="{BB962C8B-B14F-4D97-AF65-F5344CB8AC3E}">
        <p14:creationId xmlns:p14="http://schemas.microsoft.com/office/powerpoint/2010/main" val="19318557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ED97A97-C3EA-4E46-9D9E-2E09A55953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65" b="7301"/>
          <a:stretch/>
        </p:blipFill>
        <p:spPr>
          <a:xfrm>
            <a:off x="38025" y="1341655"/>
            <a:ext cx="8515666" cy="5244496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992EA99F-97D7-C04A-911F-DF19C804E6D9}"/>
              </a:ext>
            </a:extLst>
          </p:cNvPr>
          <p:cNvSpPr txBox="1">
            <a:spLocks/>
          </p:cNvSpPr>
          <p:nvPr/>
        </p:nvSpPr>
        <p:spPr>
          <a:xfrm>
            <a:off x="562307" y="887879"/>
            <a:ext cx="3299537" cy="11859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C1351C9-46C3-F440-8CAC-A67E102C67CF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8659970" y="1480864"/>
          <a:ext cx="3404708" cy="4912679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885741">
                  <a:extLst>
                    <a:ext uri="{9D8B030D-6E8A-4147-A177-3AD203B41FA5}">
                      <a16:colId xmlns:a16="http://schemas.microsoft.com/office/drawing/2014/main" val="4005626342"/>
                    </a:ext>
                  </a:extLst>
                </a:gridCol>
                <a:gridCol w="1762754">
                  <a:extLst>
                    <a:ext uri="{9D8B030D-6E8A-4147-A177-3AD203B41FA5}">
                      <a16:colId xmlns:a16="http://schemas.microsoft.com/office/drawing/2014/main" val="2934182258"/>
                    </a:ext>
                  </a:extLst>
                </a:gridCol>
                <a:gridCol w="756213">
                  <a:extLst>
                    <a:ext uri="{9D8B030D-6E8A-4147-A177-3AD203B41FA5}">
                      <a16:colId xmlns:a16="http://schemas.microsoft.com/office/drawing/2014/main" val="3802496089"/>
                    </a:ext>
                  </a:extLst>
                </a:gridCol>
              </a:tblGrid>
              <a:tr h="637105">
                <a:tc gridSpan="3">
                  <a:txBody>
                    <a:bodyPr/>
                    <a:lstStyle/>
                    <a:p>
                      <a:r>
                        <a:rPr lang="en-US" sz="2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lation characteristics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1007735"/>
                  </a:ext>
                </a:extLst>
              </a:tr>
              <a:tr h="388347">
                <a:tc rowSpan="3"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ttings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mp cutoff (℃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0113205"/>
                  </a:ext>
                </a:extLst>
              </a:tr>
              <a:tr h="388347">
                <a:tc vMerge="1">
                  <a:txBody>
                    <a:bodyPr/>
                    <a:lstStyle/>
                    <a:p>
                      <a:endPara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wer (Watts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1443879"/>
                  </a:ext>
                </a:extLst>
              </a:tr>
              <a:tr h="675387">
                <a:tc vMerge="1">
                  <a:txBody>
                    <a:bodyPr/>
                    <a:lstStyle/>
                    <a:p>
                      <a:endPara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rigating fluid (17 ml/mi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% Sali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7321041"/>
                  </a:ext>
                </a:extLst>
              </a:tr>
              <a:tr h="722533">
                <a:tc gridSpan="2"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no. of RF lesions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98635"/>
                  </a:ext>
                </a:extLst>
              </a:tr>
              <a:tr h="705802">
                <a:tc gridSpan="2"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cessful RF lesion #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1259433"/>
                  </a:ext>
                </a:extLst>
              </a:tr>
              <a:tr h="719771">
                <a:tc gridSpan="2"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 duration from 1</a:t>
                      </a:r>
                      <a:r>
                        <a:rPr lang="en-US" sz="17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</a:t>
                      </a:r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o 7</a:t>
                      </a:r>
                      <a:r>
                        <a:rPr lang="en-US" sz="17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</a:t>
                      </a:r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sion (seconds)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2964491"/>
                  </a:ext>
                </a:extLst>
              </a:tr>
              <a:tr h="675387">
                <a:tc gridSpan="2"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RF duration (seconds)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7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72712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75333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Macintosh PowerPoint</Application>
  <PresentationFormat>Widescreen</PresentationFormat>
  <Paragraphs>31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3-10-17T09:17:39Z</dcterms:created>
  <dcterms:modified xsi:type="dcterms:W3CDTF">2023-10-17T09:18:23Z</dcterms:modified>
</cp:coreProperties>
</file>